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59" r:id="rId2"/>
    <p:sldId id="261" r:id="rId3"/>
    <p:sldId id="262" r:id="rId4"/>
    <p:sldId id="278" r:id="rId5"/>
    <p:sldId id="279" r:id="rId6"/>
    <p:sldId id="280" r:id="rId7"/>
    <p:sldId id="275" r:id="rId8"/>
    <p:sldId id="281" r:id="rId9"/>
    <p:sldId id="277" r:id="rId10"/>
  </p:sldIdLst>
  <p:sldSz cx="15849600" cy="1463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8E4EC"/>
    <a:srgbClr val="C091D3"/>
    <a:srgbClr val="3366FF"/>
    <a:srgbClr val="FF7979"/>
    <a:srgbClr val="F5F93D"/>
    <a:srgbClr val="AC6D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66" autoAdjust="0"/>
    <p:restoredTop sz="96590" autoAdjust="0"/>
  </p:normalViewPr>
  <p:slideViewPr>
    <p:cSldViewPr snapToGrid="0">
      <p:cViewPr>
        <p:scale>
          <a:sx n="150" d="100"/>
          <a:sy n="150" d="100"/>
        </p:scale>
        <p:origin x="1686" y="-34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33A491-8AA4-4B7F-8A73-FB68928EAD44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57363" y="1143000"/>
            <a:ext cx="33432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B908EE-1DD8-4FB5-BAC7-1B5F436CB2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949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1pPr>
    <a:lvl2pPr marL="709574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2pPr>
    <a:lvl3pPr marL="1419149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3pPr>
    <a:lvl4pPr marL="2128723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4pPr>
    <a:lvl5pPr marL="2838298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5pPr>
    <a:lvl6pPr marL="3547872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6pPr>
    <a:lvl7pPr marL="4257446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7pPr>
    <a:lvl8pPr marL="4967021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8pPr>
    <a:lvl9pPr marL="5676595" algn="l" defTabSz="1419149" rtl="0" eaLnBrk="1" latinLnBrk="0" hangingPunct="1">
      <a:defRPr sz="18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88720" y="2394374"/>
            <a:ext cx="13472160" cy="5093547"/>
          </a:xfrm>
        </p:spPr>
        <p:txBody>
          <a:bodyPr anchor="b"/>
          <a:lstStyle>
            <a:lvl1pPr algn="ctr">
              <a:defRPr sz="10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81200" y="7684348"/>
            <a:ext cx="11887200" cy="3532292"/>
          </a:xfrm>
        </p:spPr>
        <p:txBody>
          <a:bodyPr/>
          <a:lstStyle>
            <a:lvl1pPr marL="0" indent="0" algn="ctr">
              <a:buNone/>
              <a:defRPr sz="4160"/>
            </a:lvl1pPr>
            <a:lvl2pPr marL="792465" indent="0" algn="ctr">
              <a:buNone/>
              <a:defRPr sz="3467"/>
            </a:lvl2pPr>
            <a:lvl3pPr marL="1584930" indent="0" algn="ctr">
              <a:buNone/>
              <a:defRPr sz="3120"/>
            </a:lvl3pPr>
            <a:lvl4pPr marL="2377394" indent="0" algn="ctr">
              <a:buNone/>
              <a:defRPr sz="2773"/>
            </a:lvl4pPr>
            <a:lvl5pPr marL="3169859" indent="0" algn="ctr">
              <a:buNone/>
              <a:defRPr sz="2773"/>
            </a:lvl5pPr>
            <a:lvl6pPr marL="3962324" indent="0" algn="ctr">
              <a:buNone/>
              <a:defRPr sz="2773"/>
            </a:lvl6pPr>
            <a:lvl7pPr marL="4754789" indent="0" algn="ctr">
              <a:buNone/>
              <a:defRPr sz="2773"/>
            </a:lvl7pPr>
            <a:lvl8pPr marL="5547253" indent="0" algn="ctr">
              <a:buNone/>
              <a:defRPr sz="2773"/>
            </a:lvl8pPr>
            <a:lvl9pPr marL="6339718" indent="0" algn="ctr">
              <a:buNone/>
              <a:defRPr sz="277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190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939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342371" y="778933"/>
            <a:ext cx="3417570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89661" y="778933"/>
            <a:ext cx="10054590" cy="123985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92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258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1406" y="3647444"/>
            <a:ext cx="13670280" cy="6085839"/>
          </a:xfrm>
        </p:spPr>
        <p:txBody>
          <a:bodyPr anchor="b"/>
          <a:lstStyle>
            <a:lvl1pPr>
              <a:defRPr sz="10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1406" y="9790858"/>
            <a:ext cx="13670280" cy="3200399"/>
          </a:xfrm>
        </p:spPr>
        <p:txBody>
          <a:bodyPr/>
          <a:lstStyle>
            <a:lvl1pPr marL="0" indent="0">
              <a:buNone/>
              <a:defRPr sz="4160">
                <a:solidFill>
                  <a:schemeClr val="tx1"/>
                </a:solidFill>
              </a:defRPr>
            </a:lvl1pPr>
            <a:lvl2pPr marL="792465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2pPr>
            <a:lvl3pPr marL="1584930" indent="0">
              <a:buNone/>
              <a:defRPr sz="3120">
                <a:solidFill>
                  <a:schemeClr val="tx1">
                    <a:tint val="75000"/>
                  </a:schemeClr>
                </a:solidFill>
              </a:defRPr>
            </a:lvl3pPr>
            <a:lvl4pPr marL="2377394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4pPr>
            <a:lvl5pPr marL="3169859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5pPr>
            <a:lvl6pPr marL="3962324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6pPr>
            <a:lvl7pPr marL="4754789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7pPr>
            <a:lvl8pPr marL="5547253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8pPr>
            <a:lvl9pPr marL="6339718" indent="0">
              <a:buNone/>
              <a:defRPr sz="277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86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89660" y="3894667"/>
            <a:ext cx="673608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23860" y="3894667"/>
            <a:ext cx="673608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994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724" y="778936"/>
            <a:ext cx="1367028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1726" y="3586481"/>
            <a:ext cx="6705123" cy="1757679"/>
          </a:xfrm>
        </p:spPr>
        <p:txBody>
          <a:bodyPr anchor="b"/>
          <a:lstStyle>
            <a:lvl1pPr marL="0" indent="0">
              <a:buNone/>
              <a:defRPr sz="4160" b="1"/>
            </a:lvl1pPr>
            <a:lvl2pPr marL="792465" indent="0">
              <a:buNone/>
              <a:defRPr sz="3467" b="1"/>
            </a:lvl2pPr>
            <a:lvl3pPr marL="1584930" indent="0">
              <a:buNone/>
              <a:defRPr sz="3120" b="1"/>
            </a:lvl3pPr>
            <a:lvl4pPr marL="2377394" indent="0">
              <a:buNone/>
              <a:defRPr sz="2773" b="1"/>
            </a:lvl4pPr>
            <a:lvl5pPr marL="3169859" indent="0">
              <a:buNone/>
              <a:defRPr sz="2773" b="1"/>
            </a:lvl5pPr>
            <a:lvl6pPr marL="3962324" indent="0">
              <a:buNone/>
              <a:defRPr sz="2773" b="1"/>
            </a:lvl6pPr>
            <a:lvl7pPr marL="4754789" indent="0">
              <a:buNone/>
              <a:defRPr sz="2773" b="1"/>
            </a:lvl7pPr>
            <a:lvl8pPr marL="5547253" indent="0">
              <a:buNone/>
              <a:defRPr sz="2773" b="1"/>
            </a:lvl8pPr>
            <a:lvl9pPr marL="6339718" indent="0">
              <a:buNone/>
              <a:defRPr sz="27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1726" y="5344160"/>
            <a:ext cx="6705123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23861" y="3586481"/>
            <a:ext cx="6738144" cy="1757679"/>
          </a:xfrm>
        </p:spPr>
        <p:txBody>
          <a:bodyPr anchor="b"/>
          <a:lstStyle>
            <a:lvl1pPr marL="0" indent="0">
              <a:buNone/>
              <a:defRPr sz="4160" b="1"/>
            </a:lvl1pPr>
            <a:lvl2pPr marL="792465" indent="0">
              <a:buNone/>
              <a:defRPr sz="3467" b="1"/>
            </a:lvl2pPr>
            <a:lvl3pPr marL="1584930" indent="0">
              <a:buNone/>
              <a:defRPr sz="3120" b="1"/>
            </a:lvl3pPr>
            <a:lvl4pPr marL="2377394" indent="0">
              <a:buNone/>
              <a:defRPr sz="2773" b="1"/>
            </a:lvl4pPr>
            <a:lvl5pPr marL="3169859" indent="0">
              <a:buNone/>
              <a:defRPr sz="2773" b="1"/>
            </a:lvl5pPr>
            <a:lvl6pPr marL="3962324" indent="0">
              <a:buNone/>
              <a:defRPr sz="2773" b="1"/>
            </a:lvl6pPr>
            <a:lvl7pPr marL="4754789" indent="0">
              <a:buNone/>
              <a:defRPr sz="2773" b="1"/>
            </a:lvl7pPr>
            <a:lvl8pPr marL="5547253" indent="0">
              <a:buNone/>
              <a:defRPr sz="2773" b="1"/>
            </a:lvl8pPr>
            <a:lvl9pPr marL="6339718" indent="0">
              <a:buNone/>
              <a:defRPr sz="27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023861" y="5344160"/>
            <a:ext cx="6738144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409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64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645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724" y="975360"/>
            <a:ext cx="5111909" cy="3413760"/>
          </a:xfrm>
        </p:spPr>
        <p:txBody>
          <a:bodyPr anchor="b"/>
          <a:lstStyle>
            <a:lvl1pPr>
              <a:defRPr sz="55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38144" y="2106510"/>
            <a:ext cx="8023860" cy="10397067"/>
          </a:xfrm>
        </p:spPr>
        <p:txBody>
          <a:bodyPr/>
          <a:lstStyle>
            <a:lvl1pPr>
              <a:defRPr sz="5547"/>
            </a:lvl1pPr>
            <a:lvl2pPr>
              <a:defRPr sz="4853"/>
            </a:lvl2pPr>
            <a:lvl3pPr>
              <a:defRPr sz="4160"/>
            </a:lvl3pPr>
            <a:lvl4pPr>
              <a:defRPr sz="3467"/>
            </a:lvl4pPr>
            <a:lvl5pPr>
              <a:defRPr sz="3467"/>
            </a:lvl5pPr>
            <a:lvl6pPr>
              <a:defRPr sz="3467"/>
            </a:lvl6pPr>
            <a:lvl7pPr>
              <a:defRPr sz="3467"/>
            </a:lvl7pPr>
            <a:lvl8pPr>
              <a:defRPr sz="3467"/>
            </a:lvl8pPr>
            <a:lvl9pPr>
              <a:defRPr sz="3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724" y="4389120"/>
            <a:ext cx="5111909" cy="8131388"/>
          </a:xfrm>
        </p:spPr>
        <p:txBody>
          <a:bodyPr/>
          <a:lstStyle>
            <a:lvl1pPr marL="0" indent="0">
              <a:buNone/>
              <a:defRPr sz="2773"/>
            </a:lvl1pPr>
            <a:lvl2pPr marL="792465" indent="0">
              <a:buNone/>
              <a:defRPr sz="2427"/>
            </a:lvl2pPr>
            <a:lvl3pPr marL="1584930" indent="0">
              <a:buNone/>
              <a:defRPr sz="2080"/>
            </a:lvl3pPr>
            <a:lvl4pPr marL="2377394" indent="0">
              <a:buNone/>
              <a:defRPr sz="1733"/>
            </a:lvl4pPr>
            <a:lvl5pPr marL="3169859" indent="0">
              <a:buNone/>
              <a:defRPr sz="1733"/>
            </a:lvl5pPr>
            <a:lvl6pPr marL="3962324" indent="0">
              <a:buNone/>
              <a:defRPr sz="1733"/>
            </a:lvl6pPr>
            <a:lvl7pPr marL="4754789" indent="0">
              <a:buNone/>
              <a:defRPr sz="1733"/>
            </a:lvl7pPr>
            <a:lvl8pPr marL="5547253" indent="0">
              <a:buNone/>
              <a:defRPr sz="1733"/>
            </a:lvl8pPr>
            <a:lvl9pPr marL="6339718" indent="0">
              <a:buNone/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762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724" y="975360"/>
            <a:ext cx="5111909" cy="3413760"/>
          </a:xfrm>
        </p:spPr>
        <p:txBody>
          <a:bodyPr anchor="b"/>
          <a:lstStyle>
            <a:lvl1pPr>
              <a:defRPr sz="55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38144" y="2106510"/>
            <a:ext cx="8023860" cy="10397067"/>
          </a:xfrm>
        </p:spPr>
        <p:txBody>
          <a:bodyPr anchor="t"/>
          <a:lstStyle>
            <a:lvl1pPr marL="0" indent="0">
              <a:buNone/>
              <a:defRPr sz="5547"/>
            </a:lvl1pPr>
            <a:lvl2pPr marL="792465" indent="0">
              <a:buNone/>
              <a:defRPr sz="4853"/>
            </a:lvl2pPr>
            <a:lvl3pPr marL="1584930" indent="0">
              <a:buNone/>
              <a:defRPr sz="4160"/>
            </a:lvl3pPr>
            <a:lvl4pPr marL="2377394" indent="0">
              <a:buNone/>
              <a:defRPr sz="3467"/>
            </a:lvl4pPr>
            <a:lvl5pPr marL="3169859" indent="0">
              <a:buNone/>
              <a:defRPr sz="3467"/>
            </a:lvl5pPr>
            <a:lvl6pPr marL="3962324" indent="0">
              <a:buNone/>
              <a:defRPr sz="3467"/>
            </a:lvl6pPr>
            <a:lvl7pPr marL="4754789" indent="0">
              <a:buNone/>
              <a:defRPr sz="3467"/>
            </a:lvl7pPr>
            <a:lvl8pPr marL="5547253" indent="0">
              <a:buNone/>
              <a:defRPr sz="3467"/>
            </a:lvl8pPr>
            <a:lvl9pPr marL="6339718" indent="0">
              <a:buNone/>
              <a:defRPr sz="34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724" y="4389120"/>
            <a:ext cx="5111909" cy="8131388"/>
          </a:xfrm>
        </p:spPr>
        <p:txBody>
          <a:bodyPr/>
          <a:lstStyle>
            <a:lvl1pPr marL="0" indent="0">
              <a:buNone/>
              <a:defRPr sz="2773"/>
            </a:lvl1pPr>
            <a:lvl2pPr marL="792465" indent="0">
              <a:buNone/>
              <a:defRPr sz="2427"/>
            </a:lvl2pPr>
            <a:lvl3pPr marL="1584930" indent="0">
              <a:buNone/>
              <a:defRPr sz="2080"/>
            </a:lvl3pPr>
            <a:lvl4pPr marL="2377394" indent="0">
              <a:buNone/>
              <a:defRPr sz="1733"/>
            </a:lvl4pPr>
            <a:lvl5pPr marL="3169859" indent="0">
              <a:buNone/>
              <a:defRPr sz="1733"/>
            </a:lvl5pPr>
            <a:lvl6pPr marL="3962324" indent="0">
              <a:buNone/>
              <a:defRPr sz="1733"/>
            </a:lvl6pPr>
            <a:lvl7pPr marL="4754789" indent="0">
              <a:buNone/>
              <a:defRPr sz="1733"/>
            </a:lvl7pPr>
            <a:lvl8pPr marL="5547253" indent="0">
              <a:buNone/>
              <a:defRPr sz="1733"/>
            </a:lvl8pPr>
            <a:lvl9pPr marL="6339718" indent="0">
              <a:buNone/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987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89660" y="778936"/>
            <a:ext cx="1367028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9660" y="3894667"/>
            <a:ext cx="1367028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89660" y="13560217"/>
            <a:ext cx="35661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094D-2AE6-4966-94C6-AA16B1AA88D8}" type="datetimeFigureOut">
              <a:rPr lang="en-US" smtClean="0"/>
              <a:t>10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50180" y="13560217"/>
            <a:ext cx="534924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93780" y="13560217"/>
            <a:ext cx="35661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88636-3353-49D7-8891-0427A0CD18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85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84930" rtl="0" eaLnBrk="1" latinLnBrk="0" hangingPunct="1">
        <a:lnSpc>
          <a:spcPct val="90000"/>
        </a:lnSpc>
        <a:spcBef>
          <a:spcPct val="0"/>
        </a:spcBef>
        <a:buNone/>
        <a:defRPr sz="76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6232" indent="-396232" algn="l" defTabSz="1584930" rtl="0" eaLnBrk="1" latinLnBrk="0" hangingPunct="1">
        <a:lnSpc>
          <a:spcPct val="90000"/>
        </a:lnSpc>
        <a:spcBef>
          <a:spcPts val="1733"/>
        </a:spcBef>
        <a:buFont typeface="Arial" panose="020B0604020202020204" pitchFamily="34" charset="0"/>
        <a:buChar char="•"/>
        <a:defRPr sz="4853" kern="1200">
          <a:solidFill>
            <a:schemeClr val="tx1"/>
          </a:solidFill>
          <a:latin typeface="+mn-lt"/>
          <a:ea typeface="+mn-ea"/>
          <a:cs typeface="+mn-cs"/>
        </a:defRPr>
      </a:lvl1pPr>
      <a:lvl2pPr marL="1188697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4160" kern="1200">
          <a:solidFill>
            <a:schemeClr val="tx1"/>
          </a:solidFill>
          <a:latin typeface="+mn-lt"/>
          <a:ea typeface="+mn-ea"/>
          <a:cs typeface="+mn-cs"/>
        </a:defRPr>
      </a:lvl2pPr>
      <a:lvl3pPr marL="1981162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773627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4pPr>
      <a:lvl5pPr marL="3566091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5pPr>
      <a:lvl6pPr marL="4358556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6pPr>
      <a:lvl7pPr marL="5151021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7pPr>
      <a:lvl8pPr marL="5943486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8pPr>
      <a:lvl9pPr marL="6735950" indent="-396232" algn="l" defTabSz="158493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1pPr>
      <a:lvl2pPr marL="792465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584930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3pPr>
      <a:lvl4pPr marL="2377394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4pPr>
      <a:lvl5pPr marL="3169859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5pPr>
      <a:lvl6pPr marL="3962324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6pPr>
      <a:lvl7pPr marL="4754789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7pPr>
      <a:lvl8pPr marL="5547253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8pPr>
      <a:lvl9pPr marL="6339718" algn="l" defTabSz="1584930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7A5C6C4-1494-4DF0-BE29-0C55476F19B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8705" y="6672762"/>
            <a:ext cx="6777790" cy="29838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B7244F2-2F3E-4007-9A88-48506FA552E8}"/>
              </a:ext>
            </a:extLst>
          </p:cNvPr>
          <p:cNvSpPr txBox="1"/>
          <p:nvPr/>
        </p:nvSpPr>
        <p:spPr>
          <a:xfrm>
            <a:off x="3605645" y="9656597"/>
            <a:ext cx="7855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1. Spectral properties of the 23 fluorophores on splenocytes using a 5-laser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Cytek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Aurora analyzer. a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Spectral properties of each fluorophore, where a value of 100 represents the brightest detector for each fluor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Spectral plot of each fluorophore. 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893DC48-F84F-4835-B52B-ABBD1534A3F9}"/>
              </a:ext>
            </a:extLst>
          </p:cNvPr>
          <p:cNvSpPr txBox="1"/>
          <p:nvPr/>
        </p:nvSpPr>
        <p:spPr>
          <a:xfrm>
            <a:off x="3730189" y="4000682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4CAA44-4E75-4BEE-948F-31619823E808}"/>
              </a:ext>
            </a:extLst>
          </p:cNvPr>
          <p:cNvSpPr txBox="1"/>
          <p:nvPr/>
        </p:nvSpPr>
        <p:spPr>
          <a:xfrm>
            <a:off x="3730189" y="6672762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4B44F28-139B-45CE-8844-FEA590A5A8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8705" y="4141656"/>
            <a:ext cx="6777790" cy="244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82804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8123A18-B29A-414C-BC9A-30E6304BA0FE}"/>
              </a:ext>
            </a:extLst>
          </p:cNvPr>
          <p:cNvSpPr txBox="1"/>
          <p:nvPr/>
        </p:nvSpPr>
        <p:spPr>
          <a:xfrm>
            <a:off x="1828800" y="9192371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2. Stain Index Reduction (SIR) and Hotspot Matrix. a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Higher values indicate a greater loss of resolution between the single and double positive populations and blank values indicate there is negligible loss of resolution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The hotspot matrix is a visualization of the fluorophores that cause the greatest contribution to spreading through the unmixing algorithm. Generally, the lower the value, the less spreading contribution through unmixing.</a:t>
            </a:r>
            <a:endParaRPr lang="en-US" sz="1200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DF5DF84-0FF2-4732-B799-230EF64AB541}"/>
              </a:ext>
            </a:extLst>
          </p:cNvPr>
          <p:cNvSpPr txBox="1"/>
          <p:nvPr/>
        </p:nvSpPr>
        <p:spPr>
          <a:xfrm>
            <a:off x="1457325" y="4880965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A5F249-2EB5-45F4-9633-0D0627DAE7F2}"/>
              </a:ext>
            </a:extLst>
          </p:cNvPr>
          <p:cNvSpPr txBox="1"/>
          <p:nvPr/>
        </p:nvSpPr>
        <p:spPr>
          <a:xfrm>
            <a:off x="8764899" y="4880965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DFDFD09-9ECD-4CEB-B0DE-7D65764FD6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8449" y="4880965"/>
            <a:ext cx="6858000" cy="400253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75832D1-8D47-498B-B0BD-1189240507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56023" y="4880965"/>
            <a:ext cx="5064802" cy="4001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851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1FEB4E9-0313-461A-B381-D866D1430604}"/>
              </a:ext>
            </a:extLst>
          </p:cNvPr>
          <p:cNvSpPr txBox="1"/>
          <p:nvPr/>
        </p:nvSpPr>
        <p:spPr>
          <a:xfrm>
            <a:off x="5335921" y="9111113"/>
            <a:ext cx="51777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3. Optical configuration of the 23 fluorophores on a 5-laser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Cytek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Aurora analyzer.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47F6C59-05F7-4D83-AAFA-A58F7DEEDB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6412" y="4100512"/>
            <a:ext cx="4676775" cy="4933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4904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586DD0-951C-4142-8313-1354047A0A3D}"/>
              </a:ext>
            </a:extLst>
          </p:cNvPr>
          <p:cNvSpPr txBox="1"/>
          <p:nvPr/>
        </p:nvSpPr>
        <p:spPr>
          <a:xfrm>
            <a:off x="287812" y="10716364"/>
            <a:ext cx="15273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4. Heatmaps of example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tSNEs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of myeloid populations in different tumor microenvironments (TMEs). a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4T1 cells injected SQ into mouse flank then taken 13 days after injection (n=5).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b. </a:t>
            </a:r>
            <a:r>
              <a:rPr lang="en-US" sz="1200" dirty="0" err="1">
                <a:latin typeface="Calibri" panose="020F0502020204030204" pitchFamily="34" charset="0"/>
                <a:ea typeface="Arial" panose="020B0604020202020204" pitchFamily="34" charset="0"/>
              </a:rPr>
              <a:t>HiMYC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 spontaneously developing prostate tumor (n=5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LLC cells surgically implanted into mouse flank then taken 2 weeks later (n=3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d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Prostate cancer cells injected into the tibia of mice and then taken 7 days after injection (n=5). Multigraph heat map overlays are shown.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0804D20-2D3D-4C8F-B32C-55E4E017D4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49848"/>
            <a:ext cx="7810500" cy="40481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EADE112-3AF4-450A-96EA-D078EE784A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9445" y="2349849"/>
            <a:ext cx="7886700" cy="40481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DA8ECA4-672C-466D-8B02-23F20A49C408}"/>
              </a:ext>
            </a:extLst>
          </p:cNvPr>
          <p:cNvSpPr txBox="1"/>
          <p:nvPr/>
        </p:nvSpPr>
        <p:spPr>
          <a:xfrm>
            <a:off x="2701234" y="253638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0589F9-1EFA-4412-9BE8-A21229518CA4}"/>
              </a:ext>
            </a:extLst>
          </p:cNvPr>
          <p:cNvSpPr txBox="1"/>
          <p:nvPr/>
        </p:nvSpPr>
        <p:spPr>
          <a:xfrm>
            <a:off x="3967682" y="253638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25D570E-B295-4479-B8E6-6B41F050A775}"/>
              </a:ext>
            </a:extLst>
          </p:cNvPr>
          <p:cNvSpPr txBox="1"/>
          <p:nvPr/>
        </p:nvSpPr>
        <p:spPr>
          <a:xfrm>
            <a:off x="5156839" y="253638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AFB613-ACD9-4581-A8AD-D572E5239431}"/>
              </a:ext>
            </a:extLst>
          </p:cNvPr>
          <p:cNvSpPr txBox="1"/>
          <p:nvPr/>
        </p:nvSpPr>
        <p:spPr>
          <a:xfrm>
            <a:off x="6331943" y="252574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5FEFA8-ACBE-4C99-B498-29E21577FD8E}"/>
              </a:ext>
            </a:extLst>
          </p:cNvPr>
          <p:cNvSpPr txBox="1"/>
          <p:nvPr/>
        </p:nvSpPr>
        <p:spPr>
          <a:xfrm>
            <a:off x="2679968" y="37791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B4AA46-0FC9-43EA-A618-ADCBE163A2A7}"/>
              </a:ext>
            </a:extLst>
          </p:cNvPr>
          <p:cNvSpPr txBox="1"/>
          <p:nvPr/>
        </p:nvSpPr>
        <p:spPr>
          <a:xfrm>
            <a:off x="3909656" y="37791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990A4C-67F1-4E13-A2FA-6D1F50CAD98E}"/>
              </a:ext>
            </a:extLst>
          </p:cNvPr>
          <p:cNvSpPr txBox="1"/>
          <p:nvPr/>
        </p:nvSpPr>
        <p:spPr>
          <a:xfrm>
            <a:off x="5142252" y="377918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7B5BFE-691F-4517-8DB1-411A86E8837E}"/>
              </a:ext>
            </a:extLst>
          </p:cNvPr>
          <p:cNvSpPr txBox="1"/>
          <p:nvPr/>
        </p:nvSpPr>
        <p:spPr>
          <a:xfrm>
            <a:off x="6331942" y="377918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C82D96-4DA6-4563-A65E-AF370A29B39B}"/>
              </a:ext>
            </a:extLst>
          </p:cNvPr>
          <p:cNvSpPr txBox="1"/>
          <p:nvPr/>
        </p:nvSpPr>
        <p:spPr>
          <a:xfrm>
            <a:off x="2701234" y="496067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D3E6AE-7617-421B-B134-8FF175C27C9F}"/>
              </a:ext>
            </a:extLst>
          </p:cNvPr>
          <p:cNvSpPr txBox="1"/>
          <p:nvPr/>
        </p:nvSpPr>
        <p:spPr>
          <a:xfrm>
            <a:off x="3949651" y="497856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EAD94CF-9077-4D50-ADDE-F7B9539B0004}"/>
              </a:ext>
            </a:extLst>
          </p:cNvPr>
          <p:cNvSpPr txBox="1"/>
          <p:nvPr/>
        </p:nvSpPr>
        <p:spPr>
          <a:xfrm>
            <a:off x="5156839" y="497856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A0CAD7-A9D0-494D-9C46-0FE4B09EBCAB}"/>
              </a:ext>
            </a:extLst>
          </p:cNvPr>
          <p:cNvSpPr txBox="1"/>
          <p:nvPr/>
        </p:nvSpPr>
        <p:spPr>
          <a:xfrm>
            <a:off x="6331943" y="496793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996B2F1-6407-445A-9AE9-98B06D2AC1DA}"/>
              </a:ext>
            </a:extLst>
          </p:cNvPr>
          <p:cNvSpPr txBox="1"/>
          <p:nvPr/>
        </p:nvSpPr>
        <p:spPr>
          <a:xfrm>
            <a:off x="72149" y="2208873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F18034D-B035-44F6-8B3C-2C8CA389D4F6}"/>
              </a:ext>
            </a:extLst>
          </p:cNvPr>
          <p:cNvSpPr txBox="1"/>
          <p:nvPr/>
        </p:nvSpPr>
        <p:spPr>
          <a:xfrm>
            <a:off x="7840418" y="2208873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C98D963-F433-4E2C-991C-076A021DAFB3}"/>
              </a:ext>
            </a:extLst>
          </p:cNvPr>
          <p:cNvSpPr txBox="1"/>
          <p:nvPr/>
        </p:nvSpPr>
        <p:spPr>
          <a:xfrm>
            <a:off x="10568884" y="252911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FB84657-CD58-4789-9188-60E2B39956A3}"/>
              </a:ext>
            </a:extLst>
          </p:cNvPr>
          <p:cNvSpPr txBox="1"/>
          <p:nvPr/>
        </p:nvSpPr>
        <p:spPr>
          <a:xfrm>
            <a:off x="11835332" y="252911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C8CB5A1-56AE-4A49-8F47-9DCB8D45977C}"/>
              </a:ext>
            </a:extLst>
          </p:cNvPr>
          <p:cNvSpPr txBox="1"/>
          <p:nvPr/>
        </p:nvSpPr>
        <p:spPr>
          <a:xfrm>
            <a:off x="13024489" y="252911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7836E44-34E7-422E-9C89-43E0603CB760}"/>
              </a:ext>
            </a:extLst>
          </p:cNvPr>
          <p:cNvSpPr txBox="1"/>
          <p:nvPr/>
        </p:nvSpPr>
        <p:spPr>
          <a:xfrm>
            <a:off x="14155477" y="25184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D74F7A-A56C-4C62-A708-77E2504BA26A}"/>
              </a:ext>
            </a:extLst>
          </p:cNvPr>
          <p:cNvSpPr txBox="1"/>
          <p:nvPr/>
        </p:nvSpPr>
        <p:spPr>
          <a:xfrm>
            <a:off x="10547618" y="37719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584311-D1F7-4B5B-84E3-17E26ECAED81}"/>
              </a:ext>
            </a:extLst>
          </p:cNvPr>
          <p:cNvSpPr txBox="1"/>
          <p:nvPr/>
        </p:nvSpPr>
        <p:spPr>
          <a:xfrm>
            <a:off x="11777306" y="37719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A7C3DA-ECBF-42EC-B856-ABB82959C7A9}"/>
              </a:ext>
            </a:extLst>
          </p:cNvPr>
          <p:cNvSpPr txBox="1"/>
          <p:nvPr/>
        </p:nvSpPr>
        <p:spPr>
          <a:xfrm>
            <a:off x="13009902" y="377192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C9F145D-51C6-4B27-931A-B7928924EDDA}"/>
              </a:ext>
            </a:extLst>
          </p:cNvPr>
          <p:cNvSpPr txBox="1"/>
          <p:nvPr/>
        </p:nvSpPr>
        <p:spPr>
          <a:xfrm>
            <a:off x="14155476" y="377192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EB06A35-7ABB-497A-871D-46D822B91C3C}"/>
              </a:ext>
            </a:extLst>
          </p:cNvPr>
          <p:cNvSpPr txBox="1"/>
          <p:nvPr/>
        </p:nvSpPr>
        <p:spPr>
          <a:xfrm>
            <a:off x="10568884" y="49534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CAEFC34-583E-455C-8FE2-3ED873B3AC08}"/>
              </a:ext>
            </a:extLst>
          </p:cNvPr>
          <p:cNvSpPr txBox="1"/>
          <p:nvPr/>
        </p:nvSpPr>
        <p:spPr>
          <a:xfrm>
            <a:off x="11817301" y="497130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E5884F5-0FB2-4E7D-A177-D3B996EDE492}"/>
              </a:ext>
            </a:extLst>
          </p:cNvPr>
          <p:cNvSpPr txBox="1"/>
          <p:nvPr/>
        </p:nvSpPr>
        <p:spPr>
          <a:xfrm>
            <a:off x="13024489" y="497130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6C2A888-1981-4D34-8AF6-72647EF87FAC}"/>
              </a:ext>
            </a:extLst>
          </p:cNvPr>
          <p:cNvSpPr txBox="1"/>
          <p:nvPr/>
        </p:nvSpPr>
        <p:spPr>
          <a:xfrm>
            <a:off x="14155477" y="496067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448CF51-49BA-4555-BE52-BEC07F5ABEFF}"/>
              </a:ext>
            </a:extLst>
          </p:cNvPr>
          <p:cNvSpPr txBox="1"/>
          <p:nvPr/>
        </p:nvSpPr>
        <p:spPr>
          <a:xfrm>
            <a:off x="72149" y="6361797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434552E-9FE3-4C7F-959D-793A4C6A9F58}"/>
              </a:ext>
            </a:extLst>
          </p:cNvPr>
          <p:cNvSpPr txBox="1"/>
          <p:nvPr/>
        </p:nvSpPr>
        <p:spPr>
          <a:xfrm>
            <a:off x="7840418" y="6361797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d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537AF687-54D5-42FD-B7EC-60901A7C10A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1913" y="6564067"/>
            <a:ext cx="7934325" cy="4048125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623D2E1-6668-4C27-AD24-3CDC351B32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9188" y="6564067"/>
            <a:ext cx="7896225" cy="4048125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3DF7B135-BE09-4B5C-8E2C-EA4087A53372}"/>
              </a:ext>
            </a:extLst>
          </p:cNvPr>
          <p:cNvSpPr txBox="1"/>
          <p:nvPr/>
        </p:nvSpPr>
        <p:spPr>
          <a:xfrm>
            <a:off x="2821550" y="677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80AB97A-7A90-45FE-BBEA-34CAFB25B174}"/>
              </a:ext>
            </a:extLst>
          </p:cNvPr>
          <p:cNvSpPr txBox="1"/>
          <p:nvPr/>
        </p:nvSpPr>
        <p:spPr>
          <a:xfrm>
            <a:off x="4087998" y="677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86EFFF3-2948-43F0-85AE-EF4FDCDF9144}"/>
              </a:ext>
            </a:extLst>
          </p:cNvPr>
          <p:cNvSpPr txBox="1"/>
          <p:nvPr/>
        </p:nvSpPr>
        <p:spPr>
          <a:xfrm>
            <a:off x="5277155" y="677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8719E0A-C3FF-4C07-9DFD-CC223FFD0AA9}"/>
              </a:ext>
            </a:extLst>
          </p:cNvPr>
          <p:cNvSpPr txBox="1"/>
          <p:nvPr/>
        </p:nvSpPr>
        <p:spPr>
          <a:xfrm>
            <a:off x="6404133" y="67670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745D873-492C-4D75-9AC5-5147E969DA48}"/>
              </a:ext>
            </a:extLst>
          </p:cNvPr>
          <p:cNvSpPr txBox="1"/>
          <p:nvPr/>
        </p:nvSpPr>
        <p:spPr>
          <a:xfrm>
            <a:off x="2800284" y="802050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085140E-DA25-4C50-9830-05EE5D6F0D7E}"/>
              </a:ext>
            </a:extLst>
          </p:cNvPr>
          <p:cNvSpPr txBox="1"/>
          <p:nvPr/>
        </p:nvSpPr>
        <p:spPr>
          <a:xfrm>
            <a:off x="4029972" y="802050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11A9DC1-6126-494B-A576-EECD1A4C336F}"/>
              </a:ext>
            </a:extLst>
          </p:cNvPr>
          <p:cNvSpPr txBox="1"/>
          <p:nvPr/>
        </p:nvSpPr>
        <p:spPr>
          <a:xfrm>
            <a:off x="5262568" y="802050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4FFE8F5-9019-4AB2-8504-B516EDBDE2B6}"/>
              </a:ext>
            </a:extLst>
          </p:cNvPr>
          <p:cNvSpPr txBox="1"/>
          <p:nvPr/>
        </p:nvSpPr>
        <p:spPr>
          <a:xfrm>
            <a:off x="6404132" y="802050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9648A9C-1EFE-4443-97D0-BD5C76BCE597}"/>
              </a:ext>
            </a:extLst>
          </p:cNvPr>
          <p:cNvSpPr txBox="1"/>
          <p:nvPr/>
        </p:nvSpPr>
        <p:spPr>
          <a:xfrm>
            <a:off x="2821550" y="920199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B6E2867-D4E3-48EC-B3BE-489D41ED45B7}"/>
              </a:ext>
            </a:extLst>
          </p:cNvPr>
          <p:cNvSpPr txBox="1"/>
          <p:nvPr/>
        </p:nvSpPr>
        <p:spPr>
          <a:xfrm>
            <a:off x="4069967" y="921989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C0A3A15-B1C6-4021-993E-C83D6B9CAB50}"/>
              </a:ext>
            </a:extLst>
          </p:cNvPr>
          <p:cNvSpPr txBox="1"/>
          <p:nvPr/>
        </p:nvSpPr>
        <p:spPr>
          <a:xfrm>
            <a:off x="5277155" y="921989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5568469-73FD-46E9-9228-434F07BDB554}"/>
              </a:ext>
            </a:extLst>
          </p:cNvPr>
          <p:cNvSpPr txBox="1"/>
          <p:nvPr/>
        </p:nvSpPr>
        <p:spPr>
          <a:xfrm>
            <a:off x="6404133" y="920925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8093C64-37A1-4071-B2E5-4F94526F97C6}"/>
              </a:ext>
            </a:extLst>
          </p:cNvPr>
          <p:cNvSpPr txBox="1"/>
          <p:nvPr/>
        </p:nvSpPr>
        <p:spPr>
          <a:xfrm>
            <a:off x="10720566" y="67792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6E2F4C-7BCA-40BF-8163-05CB6F74620E}"/>
              </a:ext>
            </a:extLst>
          </p:cNvPr>
          <p:cNvSpPr txBox="1"/>
          <p:nvPr/>
        </p:nvSpPr>
        <p:spPr>
          <a:xfrm>
            <a:off x="11987014" y="67792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2A8D37C-2CE7-424A-8065-0DA14BA65FDE}"/>
              </a:ext>
            </a:extLst>
          </p:cNvPr>
          <p:cNvSpPr txBox="1"/>
          <p:nvPr/>
        </p:nvSpPr>
        <p:spPr>
          <a:xfrm>
            <a:off x="13176171" y="67792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1CA0E55-9FF5-4BD7-B981-7CD28C97444C}"/>
              </a:ext>
            </a:extLst>
          </p:cNvPr>
          <p:cNvSpPr txBox="1"/>
          <p:nvPr/>
        </p:nvSpPr>
        <p:spPr>
          <a:xfrm>
            <a:off x="14303149" y="676859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6A83294-5B71-4A27-9494-EA406D84F711}"/>
              </a:ext>
            </a:extLst>
          </p:cNvPr>
          <p:cNvSpPr txBox="1"/>
          <p:nvPr/>
        </p:nvSpPr>
        <p:spPr>
          <a:xfrm>
            <a:off x="10699300" y="80220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9416B78-C7E0-496F-941A-5836B8B56BA6}"/>
              </a:ext>
            </a:extLst>
          </p:cNvPr>
          <p:cNvSpPr txBox="1"/>
          <p:nvPr/>
        </p:nvSpPr>
        <p:spPr>
          <a:xfrm>
            <a:off x="11928988" y="80220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F6A7476-CF05-47B8-AD0C-E58FC25EFA39}"/>
              </a:ext>
            </a:extLst>
          </p:cNvPr>
          <p:cNvSpPr txBox="1"/>
          <p:nvPr/>
        </p:nvSpPr>
        <p:spPr>
          <a:xfrm>
            <a:off x="13161584" y="802203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13F5742-589A-4FEC-BB8F-B29A9A608E58}"/>
              </a:ext>
            </a:extLst>
          </p:cNvPr>
          <p:cNvSpPr txBox="1"/>
          <p:nvPr/>
        </p:nvSpPr>
        <p:spPr>
          <a:xfrm>
            <a:off x="14303148" y="802203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00D6154-4C3E-4DBD-B446-A1ED24111476}"/>
              </a:ext>
            </a:extLst>
          </p:cNvPr>
          <p:cNvSpPr txBox="1"/>
          <p:nvPr/>
        </p:nvSpPr>
        <p:spPr>
          <a:xfrm>
            <a:off x="10720566" y="920351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3FDFFD9-1FA5-4424-8053-C00D3A557003}"/>
              </a:ext>
            </a:extLst>
          </p:cNvPr>
          <p:cNvSpPr txBox="1"/>
          <p:nvPr/>
        </p:nvSpPr>
        <p:spPr>
          <a:xfrm>
            <a:off x="11968983" y="922141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ED2F0A5-6721-4DA6-AC7F-5A55464E2456}"/>
              </a:ext>
            </a:extLst>
          </p:cNvPr>
          <p:cNvSpPr txBox="1"/>
          <p:nvPr/>
        </p:nvSpPr>
        <p:spPr>
          <a:xfrm>
            <a:off x="13176171" y="92214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BE67345-EDBB-4B96-AB10-FBF8ABFED77F}"/>
              </a:ext>
            </a:extLst>
          </p:cNvPr>
          <p:cNvSpPr txBox="1"/>
          <p:nvPr/>
        </p:nvSpPr>
        <p:spPr>
          <a:xfrm>
            <a:off x="14303149" y="921077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474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99FBE7-87C9-460C-8616-9B62CF64276B}"/>
              </a:ext>
            </a:extLst>
          </p:cNvPr>
          <p:cNvSpPr txBox="1"/>
          <p:nvPr/>
        </p:nvSpPr>
        <p:spPr>
          <a:xfrm>
            <a:off x="72148" y="12257873"/>
            <a:ext cx="15777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5. Heatmap of example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tSNEs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of lymphoid populations in different tumor microenvironments (TMEs). a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4T1 cells injected SQ into mouse flank then taken 13 days after injection (n=5).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b. </a:t>
            </a:r>
            <a:r>
              <a:rPr lang="en-US" sz="1200" dirty="0" err="1">
                <a:latin typeface="Calibri" panose="020F0502020204030204" pitchFamily="34" charset="0"/>
                <a:ea typeface="Arial" panose="020B0604020202020204" pitchFamily="34" charset="0"/>
              </a:rPr>
              <a:t>HiMYC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 spontaneously developing prostate tumor (n=5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LLC cells surgically implanted into mouse flank then taken 2 weeks later (n=3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d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Prostate cancer cells injected into the tibia of mice and then taken 7 days after injection (n=5). Multigraph heat map overlays are shown.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5B5C49-9193-4E7D-A48A-FD29751731FF}"/>
              </a:ext>
            </a:extLst>
          </p:cNvPr>
          <p:cNvSpPr txBox="1"/>
          <p:nvPr/>
        </p:nvSpPr>
        <p:spPr>
          <a:xfrm>
            <a:off x="72149" y="1085922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3CB1FEB-E910-4FE4-92C3-70E1E142FB5B}"/>
              </a:ext>
            </a:extLst>
          </p:cNvPr>
          <p:cNvSpPr txBox="1"/>
          <p:nvPr/>
        </p:nvSpPr>
        <p:spPr>
          <a:xfrm>
            <a:off x="7840418" y="1085922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016337-EB28-425F-BEC5-6192F405E358}"/>
              </a:ext>
            </a:extLst>
          </p:cNvPr>
          <p:cNvSpPr txBox="1"/>
          <p:nvPr/>
        </p:nvSpPr>
        <p:spPr>
          <a:xfrm>
            <a:off x="72149" y="6859099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5FF8A4E-E602-49BB-BAB4-47E07D8B29A3}"/>
              </a:ext>
            </a:extLst>
          </p:cNvPr>
          <p:cNvSpPr txBox="1"/>
          <p:nvPr/>
        </p:nvSpPr>
        <p:spPr>
          <a:xfrm>
            <a:off x="7840418" y="6859099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d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4455415-2717-4713-B7C9-DBB295EB07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85922"/>
            <a:ext cx="7848600" cy="526732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FF0486C-A570-4B46-98FD-53DFCD572A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1975" y="1085922"/>
            <a:ext cx="7905750" cy="526732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B96DD6E-DA7D-40B5-BB29-F27DE75DCB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9050" y="7000073"/>
            <a:ext cx="7886700" cy="5257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A144A30-99D9-410C-A0F3-3C5924FC93E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9700" y="6995311"/>
            <a:ext cx="7915275" cy="526732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C34022D-520D-45A2-8C78-BC40EEDFEA44}"/>
              </a:ext>
            </a:extLst>
          </p:cNvPr>
          <p:cNvSpPr txBox="1"/>
          <p:nvPr/>
        </p:nvSpPr>
        <p:spPr>
          <a:xfrm>
            <a:off x="2769413" y="12770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FB872E2-D8B4-4FCB-BA13-C5F5BC7C5320}"/>
              </a:ext>
            </a:extLst>
          </p:cNvPr>
          <p:cNvSpPr txBox="1"/>
          <p:nvPr/>
        </p:nvSpPr>
        <p:spPr>
          <a:xfrm>
            <a:off x="4035861" y="12770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4617F2-1AE4-4871-B130-C83614743A1A}"/>
              </a:ext>
            </a:extLst>
          </p:cNvPr>
          <p:cNvSpPr txBox="1"/>
          <p:nvPr/>
        </p:nvSpPr>
        <p:spPr>
          <a:xfrm>
            <a:off x="5225018" y="12770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9D6E32-7E27-4C18-BF63-9EE810C61A3E}"/>
              </a:ext>
            </a:extLst>
          </p:cNvPr>
          <p:cNvSpPr txBox="1"/>
          <p:nvPr/>
        </p:nvSpPr>
        <p:spPr>
          <a:xfrm>
            <a:off x="6400122" y="126643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A110414-85E7-460E-9030-73AB9D9E91ED}"/>
              </a:ext>
            </a:extLst>
          </p:cNvPr>
          <p:cNvSpPr txBox="1"/>
          <p:nvPr/>
        </p:nvSpPr>
        <p:spPr>
          <a:xfrm>
            <a:off x="2760179" y="251987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F15857B-D6C7-422C-97BE-56EB55917191}"/>
              </a:ext>
            </a:extLst>
          </p:cNvPr>
          <p:cNvSpPr txBox="1"/>
          <p:nvPr/>
        </p:nvSpPr>
        <p:spPr>
          <a:xfrm>
            <a:off x="3989867" y="251987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2AA417A-F205-4CDF-993E-0815FEDDC536}"/>
              </a:ext>
            </a:extLst>
          </p:cNvPr>
          <p:cNvSpPr txBox="1"/>
          <p:nvPr/>
        </p:nvSpPr>
        <p:spPr>
          <a:xfrm>
            <a:off x="5222463" y="251987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0319E6-4BFA-4B27-94A8-ABF3301B8418}"/>
              </a:ext>
            </a:extLst>
          </p:cNvPr>
          <p:cNvSpPr txBox="1"/>
          <p:nvPr/>
        </p:nvSpPr>
        <p:spPr>
          <a:xfrm>
            <a:off x="6412153" y="251987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1326CD5-208D-400B-921F-AA5D0A9A82EA}"/>
              </a:ext>
            </a:extLst>
          </p:cNvPr>
          <p:cNvSpPr txBox="1"/>
          <p:nvPr/>
        </p:nvSpPr>
        <p:spPr>
          <a:xfrm>
            <a:off x="2769413" y="370136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CE4F7B-69B1-46EF-8598-B51605E74280}"/>
              </a:ext>
            </a:extLst>
          </p:cNvPr>
          <p:cNvSpPr txBox="1"/>
          <p:nvPr/>
        </p:nvSpPr>
        <p:spPr>
          <a:xfrm>
            <a:off x="4017830" y="37192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E7DBCDF-573C-41C8-802E-CA0E029B43F1}"/>
              </a:ext>
            </a:extLst>
          </p:cNvPr>
          <p:cNvSpPr txBox="1"/>
          <p:nvPr/>
        </p:nvSpPr>
        <p:spPr>
          <a:xfrm>
            <a:off x="5225018" y="3719257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36144F4-51BD-4398-B05F-6F60F98D8B6B}"/>
              </a:ext>
            </a:extLst>
          </p:cNvPr>
          <p:cNvSpPr txBox="1"/>
          <p:nvPr/>
        </p:nvSpPr>
        <p:spPr>
          <a:xfrm>
            <a:off x="6400122" y="3708624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1AEEFD9-4434-4089-819B-4EEB80E546FA}"/>
              </a:ext>
            </a:extLst>
          </p:cNvPr>
          <p:cNvSpPr txBox="1"/>
          <p:nvPr/>
        </p:nvSpPr>
        <p:spPr>
          <a:xfrm>
            <a:off x="2754430" y="494659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99E46AC-02B1-434E-9C64-FA73D10ABDA6}"/>
              </a:ext>
            </a:extLst>
          </p:cNvPr>
          <p:cNvSpPr txBox="1"/>
          <p:nvPr/>
        </p:nvSpPr>
        <p:spPr>
          <a:xfrm>
            <a:off x="4020878" y="494659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F6EA8D-BBAB-416C-A2AB-6443DF170FA1}"/>
              </a:ext>
            </a:extLst>
          </p:cNvPr>
          <p:cNvSpPr txBox="1"/>
          <p:nvPr/>
        </p:nvSpPr>
        <p:spPr>
          <a:xfrm>
            <a:off x="5210035" y="494659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1189456-7EB8-49D2-82AB-9898EDCEB4DC}"/>
              </a:ext>
            </a:extLst>
          </p:cNvPr>
          <p:cNvSpPr txBox="1"/>
          <p:nvPr/>
        </p:nvSpPr>
        <p:spPr>
          <a:xfrm>
            <a:off x="10611996" y="128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76CE0C-AFDF-40A8-B44E-2953DC7C1D8A}"/>
              </a:ext>
            </a:extLst>
          </p:cNvPr>
          <p:cNvSpPr txBox="1"/>
          <p:nvPr/>
        </p:nvSpPr>
        <p:spPr>
          <a:xfrm>
            <a:off x="11878444" y="128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4DBBEC5-F173-4DE6-AC55-D57D15BC018E}"/>
              </a:ext>
            </a:extLst>
          </p:cNvPr>
          <p:cNvSpPr txBox="1"/>
          <p:nvPr/>
        </p:nvSpPr>
        <p:spPr>
          <a:xfrm>
            <a:off x="13067601" y="128770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A08A3EC-9DEE-41A2-B72B-E5A0C08E42B3}"/>
              </a:ext>
            </a:extLst>
          </p:cNvPr>
          <p:cNvSpPr txBox="1"/>
          <p:nvPr/>
        </p:nvSpPr>
        <p:spPr>
          <a:xfrm>
            <a:off x="14242705" y="12770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816AF33-9FB0-4217-8E4F-3D8145DBB05E}"/>
              </a:ext>
            </a:extLst>
          </p:cNvPr>
          <p:cNvSpPr txBox="1"/>
          <p:nvPr/>
        </p:nvSpPr>
        <p:spPr>
          <a:xfrm>
            <a:off x="10602762" y="253050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2752EA2-250A-4F17-BCBA-0757933908D8}"/>
              </a:ext>
            </a:extLst>
          </p:cNvPr>
          <p:cNvSpPr txBox="1"/>
          <p:nvPr/>
        </p:nvSpPr>
        <p:spPr>
          <a:xfrm>
            <a:off x="11832450" y="253050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7AD8D71-4D2C-4A00-B531-30EF8ABA0361}"/>
              </a:ext>
            </a:extLst>
          </p:cNvPr>
          <p:cNvSpPr txBox="1"/>
          <p:nvPr/>
        </p:nvSpPr>
        <p:spPr>
          <a:xfrm>
            <a:off x="13065046" y="253050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E89700B-D706-492F-9EE0-5058038AFA26}"/>
              </a:ext>
            </a:extLst>
          </p:cNvPr>
          <p:cNvSpPr txBox="1"/>
          <p:nvPr/>
        </p:nvSpPr>
        <p:spPr>
          <a:xfrm>
            <a:off x="14254736" y="253050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E08F1F6-3155-47E7-89D6-C2F2FD40F30C}"/>
              </a:ext>
            </a:extLst>
          </p:cNvPr>
          <p:cNvSpPr txBox="1"/>
          <p:nvPr/>
        </p:nvSpPr>
        <p:spPr>
          <a:xfrm>
            <a:off x="10611996" y="371199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E8A1F17-795B-4C30-B82F-DD317456D8B0}"/>
              </a:ext>
            </a:extLst>
          </p:cNvPr>
          <p:cNvSpPr txBox="1"/>
          <p:nvPr/>
        </p:nvSpPr>
        <p:spPr>
          <a:xfrm>
            <a:off x="11860413" y="372989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9D60A51-C79F-4E86-B703-A5953EC89C25}"/>
              </a:ext>
            </a:extLst>
          </p:cNvPr>
          <p:cNvSpPr txBox="1"/>
          <p:nvPr/>
        </p:nvSpPr>
        <p:spPr>
          <a:xfrm>
            <a:off x="13067601" y="3729890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2234807-4F2B-4362-B08D-C0D85B178CDA}"/>
              </a:ext>
            </a:extLst>
          </p:cNvPr>
          <p:cNvSpPr txBox="1"/>
          <p:nvPr/>
        </p:nvSpPr>
        <p:spPr>
          <a:xfrm>
            <a:off x="14242705" y="3719257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25635CE-8A76-45A0-BCF1-7DE697AAA87E}"/>
              </a:ext>
            </a:extLst>
          </p:cNvPr>
          <p:cNvSpPr txBox="1"/>
          <p:nvPr/>
        </p:nvSpPr>
        <p:spPr>
          <a:xfrm>
            <a:off x="10597013" y="495722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16C8C91-80E1-493B-A422-C55359971280}"/>
              </a:ext>
            </a:extLst>
          </p:cNvPr>
          <p:cNvSpPr txBox="1"/>
          <p:nvPr/>
        </p:nvSpPr>
        <p:spPr>
          <a:xfrm>
            <a:off x="11863461" y="495722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9D82F2A-3C5A-4509-9678-90915630CA76}"/>
              </a:ext>
            </a:extLst>
          </p:cNvPr>
          <p:cNvSpPr txBox="1"/>
          <p:nvPr/>
        </p:nvSpPr>
        <p:spPr>
          <a:xfrm>
            <a:off x="13052618" y="495722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ED4B551-DCC5-4888-A1F8-1BFD835D81A4}"/>
              </a:ext>
            </a:extLst>
          </p:cNvPr>
          <p:cNvSpPr txBox="1"/>
          <p:nvPr/>
        </p:nvSpPr>
        <p:spPr>
          <a:xfrm>
            <a:off x="2782144" y="71650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8ACB172-2138-4FF6-9DFE-241A5290ABAB}"/>
              </a:ext>
            </a:extLst>
          </p:cNvPr>
          <p:cNvSpPr txBox="1"/>
          <p:nvPr/>
        </p:nvSpPr>
        <p:spPr>
          <a:xfrm>
            <a:off x="4048592" y="71650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C8EE2B4-E491-44E0-BF68-6D66FD6B9217}"/>
              </a:ext>
            </a:extLst>
          </p:cNvPr>
          <p:cNvSpPr txBox="1"/>
          <p:nvPr/>
        </p:nvSpPr>
        <p:spPr>
          <a:xfrm>
            <a:off x="5237749" y="716508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5D979ED-A785-4459-90B1-29CE2E61BE31}"/>
              </a:ext>
            </a:extLst>
          </p:cNvPr>
          <p:cNvSpPr txBox="1"/>
          <p:nvPr/>
        </p:nvSpPr>
        <p:spPr>
          <a:xfrm>
            <a:off x="6412853" y="71544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E3F4886-D5EB-4B3F-B771-9D8F87A892A2}"/>
              </a:ext>
            </a:extLst>
          </p:cNvPr>
          <p:cNvSpPr txBox="1"/>
          <p:nvPr/>
        </p:nvSpPr>
        <p:spPr>
          <a:xfrm>
            <a:off x="2772910" y="840789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A1A5FD3-2E39-419C-8E92-48EE36D58EA7}"/>
              </a:ext>
            </a:extLst>
          </p:cNvPr>
          <p:cNvSpPr txBox="1"/>
          <p:nvPr/>
        </p:nvSpPr>
        <p:spPr>
          <a:xfrm>
            <a:off x="4002598" y="840789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1D12FB1-659B-4E8D-8644-5034F58035B8}"/>
              </a:ext>
            </a:extLst>
          </p:cNvPr>
          <p:cNvSpPr txBox="1"/>
          <p:nvPr/>
        </p:nvSpPr>
        <p:spPr>
          <a:xfrm>
            <a:off x="5235194" y="840789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AB77022-ABF4-4B76-8AE1-ADEE4EAD4E5E}"/>
              </a:ext>
            </a:extLst>
          </p:cNvPr>
          <p:cNvSpPr txBox="1"/>
          <p:nvPr/>
        </p:nvSpPr>
        <p:spPr>
          <a:xfrm>
            <a:off x="6424884" y="840789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6CF460-E120-49D3-B946-4D45002C81B1}"/>
              </a:ext>
            </a:extLst>
          </p:cNvPr>
          <p:cNvSpPr txBox="1"/>
          <p:nvPr/>
        </p:nvSpPr>
        <p:spPr>
          <a:xfrm>
            <a:off x="2782144" y="958937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114BEBB-F875-4521-8E86-33C5B89F20A8}"/>
              </a:ext>
            </a:extLst>
          </p:cNvPr>
          <p:cNvSpPr txBox="1"/>
          <p:nvPr/>
        </p:nvSpPr>
        <p:spPr>
          <a:xfrm>
            <a:off x="4030561" y="960727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75A60C7-EF4D-4389-95BD-E5724AAE8522}"/>
              </a:ext>
            </a:extLst>
          </p:cNvPr>
          <p:cNvSpPr txBox="1"/>
          <p:nvPr/>
        </p:nvSpPr>
        <p:spPr>
          <a:xfrm>
            <a:off x="5237749" y="9607273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6C5D548-606A-4AC0-8DA9-53600EF502B0}"/>
              </a:ext>
            </a:extLst>
          </p:cNvPr>
          <p:cNvSpPr txBox="1"/>
          <p:nvPr/>
        </p:nvSpPr>
        <p:spPr>
          <a:xfrm>
            <a:off x="6412853" y="9596640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212EF4F-E50C-4B34-8DFB-73AE15AB7CCB}"/>
              </a:ext>
            </a:extLst>
          </p:cNvPr>
          <p:cNvSpPr txBox="1"/>
          <p:nvPr/>
        </p:nvSpPr>
        <p:spPr>
          <a:xfrm>
            <a:off x="2767161" y="108346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7E2A75E-4FE7-4E82-ABA4-A44CB96763CD}"/>
              </a:ext>
            </a:extLst>
          </p:cNvPr>
          <p:cNvSpPr txBox="1"/>
          <p:nvPr/>
        </p:nvSpPr>
        <p:spPr>
          <a:xfrm>
            <a:off x="4033609" y="108346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7C2C3B4-1C64-4355-938D-EA47926796B1}"/>
              </a:ext>
            </a:extLst>
          </p:cNvPr>
          <p:cNvSpPr txBox="1"/>
          <p:nvPr/>
        </p:nvSpPr>
        <p:spPr>
          <a:xfrm>
            <a:off x="5222766" y="108346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259C960-97FF-401F-9846-1D12554A4D98}"/>
              </a:ext>
            </a:extLst>
          </p:cNvPr>
          <p:cNvSpPr txBox="1"/>
          <p:nvPr/>
        </p:nvSpPr>
        <p:spPr>
          <a:xfrm>
            <a:off x="10668844" y="71906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3EDAC2A-2E9F-4E3E-80F3-7B38F8F6F6C7}"/>
              </a:ext>
            </a:extLst>
          </p:cNvPr>
          <p:cNvSpPr txBox="1"/>
          <p:nvPr/>
        </p:nvSpPr>
        <p:spPr>
          <a:xfrm>
            <a:off x="11935292" y="71906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1A0B5FA-31F7-4DD4-B437-6809A7114C55}"/>
              </a:ext>
            </a:extLst>
          </p:cNvPr>
          <p:cNvSpPr txBox="1"/>
          <p:nvPr/>
        </p:nvSpPr>
        <p:spPr>
          <a:xfrm>
            <a:off x="13124449" y="719062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DEE2035-B39F-4833-915F-F4AA0690A39C}"/>
              </a:ext>
            </a:extLst>
          </p:cNvPr>
          <p:cNvSpPr txBox="1"/>
          <p:nvPr/>
        </p:nvSpPr>
        <p:spPr>
          <a:xfrm>
            <a:off x="14299553" y="717999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F105456-60EF-456C-A471-635811E7A5D8}"/>
              </a:ext>
            </a:extLst>
          </p:cNvPr>
          <p:cNvSpPr txBox="1"/>
          <p:nvPr/>
        </p:nvSpPr>
        <p:spPr>
          <a:xfrm>
            <a:off x="10659610" y="84334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176D231-FA7E-43BE-A1FD-B6F61295E6B1}"/>
              </a:ext>
            </a:extLst>
          </p:cNvPr>
          <p:cNvSpPr txBox="1"/>
          <p:nvPr/>
        </p:nvSpPr>
        <p:spPr>
          <a:xfrm>
            <a:off x="11889298" y="84334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C9E37D3-5402-49FA-8615-D322C74C9B2A}"/>
              </a:ext>
            </a:extLst>
          </p:cNvPr>
          <p:cNvSpPr txBox="1"/>
          <p:nvPr/>
        </p:nvSpPr>
        <p:spPr>
          <a:xfrm>
            <a:off x="13121894" y="843343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6F35D38-54B0-4DD4-B5E7-3C9D90A23426}"/>
              </a:ext>
            </a:extLst>
          </p:cNvPr>
          <p:cNvSpPr txBox="1"/>
          <p:nvPr/>
        </p:nvSpPr>
        <p:spPr>
          <a:xfrm>
            <a:off x="14311584" y="843343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660A751-F974-46DA-8FAB-AD248CC2B16D}"/>
              </a:ext>
            </a:extLst>
          </p:cNvPr>
          <p:cNvSpPr txBox="1"/>
          <p:nvPr/>
        </p:nvSpPr>
        <p:spPr>
          <a:xfrm>
            <a:off x="10668844" y="961491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1CB0DB6-C795-47B5-9402-CB32D5303757}"/>
              </a:ext>
            </a:extLst>
          </p:cNvPr>
          <p:cNvSpPr txBox="1"/>
          <p:nvPr/>
        </p:nvSpPr>
        <p:spPr>
          <a:xfrm>
            <a:off x="11917261" y="963281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82A0196-A173-44FB-A73B-B76F7B7A800F}"/>
              </a:ext>
            </a:extLst>
          </p:cNvPr>
          <p:cNvSpPr txBox="1"/>
          <p:nvPr/>
        </p:nvSpPr>
        <p:spPr>
          <a:xfrm>
            <a:off x="13124449" y="9632812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06423D0-348B-486B-8C36-A5FF7DC7556A}"/>
              </a:ext>
            </a:extLst>
          </p:cNvPr>
          <p:cNvSpPr txBox="1"/>
          <p:nvPr/>
        </p:nvSpPr>
        <p:spPr>
          <a:xfrm>
            <a:off x="14299553" y="9622179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4EBDE85-5D4D-42A2-99E9-C28A3F654F74}"/>
              </a:ext>
            </a:extLst>
          </p:cNvPr>
          <p:cNvSpPr txBox="1"/>
          <p:nvPr/>
        </p:nvSpPr>
        <p:spPr>
          <a:xfrm>
            <a:off x="10653861" y="1086015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D34981A-6297-46A9-BCEC-E49FFA5E1BBB}"/>
              </a:ext>
            </a:extLst>
          </p:cNvPr>
          <p:cNvSpPr txBox="1"/>
          <p:nvPr/>
        </p:nvSpPr>
        <p:spPr>
          <a:xfrm>
            <a:off x="11920309" y="1086015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A25AD89-EDD2-4102-8825-DC89046079FE}"/>
              </a:ext>
            </a:extLst>
          </p:cNvPr>
          <p:cNvSpPr txBox="1"/>
          <p:nvPr/>
        </p:nvSpPr>
        <p:spPr>
          <a:xfrm>
            <a:off x="13109466" y="1086015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167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B9E0D3F-4DAE-49C9-87B1-EB3DC51BA32A}"/>
              </a:ext>
            </a:extLst>
          </p:cNvPr>
          <p:cNvSpPr txBox="1"/>
          <p:nvPr/>
        </p:nvSpPr>
        <p:spPr>
          <a:xfrm>
            <a:off x="-19050" y="14149685"/>
            <a:ext cx="1584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6. Heatmaps of example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tSNEs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of myeloid and lymphoid populations in various sample types.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Populations in the brain (n=3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Populations in blood (n=5). 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Populations in mammary gland (n=4). Multigraph heat map overlays are shown. 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A5E0CB9-F59D-41C1-BAD4-5CE0C219A87C}"/>
              </a:ext>
            </a:extLst>
          </p:cNvPr>
          <p:cNvSpPr txBox="1"/>
          <p:nvPr/>
        </p:nvSpPr>
        <p:spPr>
          <a:xfrm>
            <a:off x="0" y="19050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a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8FFFDB3-8B90-48FD-B65D-B2DCA25C4CFD}"/>
              </a:ext>
            </a:extLst>
          </p:cNvPr>
          <p:cNvSpPr txBox="1"/>
          <p:nvPr/>
        </p:nvSpPr>
        <p:spPr>
          <a:xfrm>
            <a:off x="7874547" y="19050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b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61E187-07A4-4DEA-82C6-CA446942A4F3}"/>
              </a:ext>
            </a:extLst>
          </p:cNvPr>
          <p:cNvSpPr txBox="1"/>
          <p:nvPr/>
        </p:nvSpPr>
        <p:spPr>
          <a:xfrm>
            <a:off x="0" y="8821685"/>
            <a:ext cx="332674" cy="28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6CD718A-ACF9-44CD-B75F-4AFEE063B3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49" y="19050"/>
            <a:ext cx="7886700" cy="770572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E70394B-F5DB-4615-8A5B-E2D9B82EBF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2651" y="19050"/>
            <a:ext cx="7924800" cy="404812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A8B2ADF-D405-4898-988D-9267FE98C6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4800" y="3862502"/>
            <a:ext cx="7905750" cy="526732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01EC1A1-D0BD-442D-AA6C-E5F1FF7009A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184" y="8962659"/>
            <a:ext cx="7886700" cy="405765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D1B2C50-9CD9-4130-8CC8-2C00361137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2147" y="8962659"/>
            <a:ext cx="7848600" cy="526732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8628C78-05B0-4236-AF16-12DAEC69ABE5}"/>
              </a:ext>
            </a:extLst>
          </p:cNvPr>
          <p:cNvSpPr txBox="1"/>
          <p:nvPr/>
        </p:nvSpPr>
        <p:spPr>
          <a:xfrm>
            <a:off x="10764935" y="405524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5FC3D46-8B3B-467E-8D34-E6C39BCE86C9}"/>
              </a:ext>
            </a:extLst>
          </p:cNvPr>
          <p:cNvSpPr txBox="1"/>
          <p:nvPr/>
        </p:nvSpPr>
        <p:spPr>
          <a:xfrm>
            <a:off x="12031383" y="405524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99DBCED-AC65-463B-9956-B0FC85C28932}"/>
              </a:ext>
            </a:extLst>
          </p:cNvPr>
          <p:cNvSpPr txBox="1"/>
          <p:nvPr/>
        </p:nvSpPr>
        <p:spPr>
          <a:xfrm>
            <a:off x="13220540" y="405524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0E9E7A5-3F94-4D95-9085-AD32DE4B4999}"/>
              </a:ext>
            </a:extLst>
          </p:cNvPr>
          <p:cNvSpPr txBox="1"/>
          <p:nvPr/>
        </p:nvSpPr>
        <p:spPr>
          <a:xfrm>
            <a:off x="14395644" y="404461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DB8E0F-8C2A-477E-9B05-62368BF8E4F3}"/>
              </a:ext>
            </a:extLst>
          </p:cNvPr>
          <p:cNvSpPr txBox="1"/>
          <p:nvPr/>
        </p:nvSpPr>
        <p:spPr>
          <a:xfrm>
            <a:off x="10755701" y="529805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C42827-ABEA-4784-9ED8-308F6C7B16E4}"/>
              </a:ext>
            </a:extLst>
          </p:cNvPr>
          <p:cNvSpPr txBox="1"/>
          <p:nvPr/>
        </p:nvSpPr>
        <p:spPr>
          <a:xfrm>
            <a:off x="11985389" y="529805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D299BF-1736-43CC-BDDC-65E5D4238382}"/>
              </a:ext>
            </a:extLst>
          </p:cNvPr>
          <p:cNvSpPr txBox="1"/>
          <p:nvPr/>
        </p:nvSpPr>
        <p:spPr>
          <a:xfrm>
            <a:off x="13217985" y="529805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9E4378C-E894-4F62-BDDC-B030AC36FF99}"/>
              </a:ext>
            </a:extLst>
          </p:cNvPr>
          <p:cNvSpPr txBox="1"/>
          <p:nvPr/>
        </p:nvSpPr>
        <p:spPr>
          <a:xfrm>
            <a:off x="14407675" y="529805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F59D3B5-343F-4E35-B753-7A6962C6E9CD}"/>
              </a:ext>
            </a:extLst>
          </p:cNvPr>
          <p:cNvSpPr txBox="1"/>
          <p:nvPr/>
        </p:nvSpPr>
        <p:spPr>
          <a:xfrm>
            <a:off x="10764935" y="647954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C39D3F5-3ACE-4825-9863-BB15447786F3}"/>
              </a:ext>
            </a:extLst>
          </p:cNvPr>
          <p:cNvSpPr txBox="1"/>
          <p:nvPr/>
        </p:nvSpPr>
        <p:spPr>
          <a:xfrm>
            <a:off x="12013352" y="649743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7B2A9D8-CDEB-470D-82FE-55BF34BE2130}"/>
              </a:ext>
            </a:extLst>
          </p:cNvPr>
          <p:cNvSpPr txBox="1"/>
          <p:nvPr/>
        </p:nvSpPr>
        <p:spPr>
          <a:xfrm>
            <a:off x="13220540" y="6497436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5011BC9-CCD9-466D-B445-E02293FA09D2}"/>
              </a:ext>
            </a:extLst>
          </p:cNvPr>
          <p:cNvSpPr txBox="1"/>
          <p:nvPr/>
        </p:nvSpPr>
        <p:spPr>
          <a:xfrm>
            <a:off x="14395644" y="6486803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B05BD3D-8872-4E81-B067-4227C8B75626}"/>
              </a:ext>
            </a:extLst>
          </p:cNvPr>
          <p:cNvSpPr txBox="1"/>
          <p:nvPr/>
        </p:nvSpPr>
        <p:spPr>
          <a:xfrm>
            <a:off x="10749952" y="772477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082EEE-3D96-44C9-85F8-21E18829B3C8}"/>
              </a:ext>
            </a:extLst>
          </p:cNvPr>
          <p:cNvSpPr txBox="1"/>
          <p:nvPr/>
        </p:nvSpPr>
        <p:spPr>
          <a:xfrm>
            <a:off x="12016400" y="772477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9043831-4ABB-43FB-B8E8-C2166D9A1A20}"/>
              </a:ext>
            </a:extLst>
          </p:cNvPr>
          <p:cNvSpPr txBox="1"/>
          <p:nvPr/>
        </p:nvSpPr>
        <p:spPr>
          <a:xfrm>
            <a:off x="13205557" y="772477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AB1E2CE-5BC6-4A6A-A1E0-78021046030D}"/>
              </a:ext>
            </a:extLst>
          </p:cNvPr>
          <p:cNvSpPr txBox="1"/>
          <p:nvPr/>
        </p:nvSpPr>
        <p:spPr>
          <a:xfrm>
            <a:off x="10512153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22C6BA9-8FCE-44A9-96B9-729708FC5715}"/>
              </a:ext>
            </a:extLst>
          </p:cNvPr>
          <p:cNvSpPr txBox="1"/>
          <p:nvPr/>
        </p:nvSpPr>
        <p:spPr>
          <a:xfrm>
            <a:off x="11778601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DE54809-197B-4B06-9A4F-D29C41A160EB}"/>
              </a:ext>
            </a:extLst>
          </p:cNvPr>
          <p:cNvSpPr txBox="1"/>
          <p:nvPr/>
        </p:nvSpPr>
        <p:spPr>
          <a:xfrm>
            <a:off x="12967758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F624ED0-E968-4352-A9C1-4D830C4E8F45}"/>
              </a:ext>
            </a:extLst>
          </p:cNvPr>
          <p:cNvSpPr txBox="1"/>
          <p:nvPr/>
        </p:nvSpPr>
        <p:spPr>
          <a:xfrm>
            <a:off x="14142862" y="915462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BA15E88-0FF8-4916-B660-41EDD21CB143}"/>
              </a:ext>
            </a:extLst>
          </p:cNvPr>
          <p:cNvSpPr txBox="1"/>
          <p:nvPr/>
        </p:nvSpPr>
        <p:spPr>
          <a:xfrm>
            <a:off x="10502919" y="1040805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92DBA24-C0BD-4951-8434-CAF2E1665219}"/>
              </a:ext>
            </a:extLst>
          </p:cNvPr>
          <p:cNvSpPr txBox="1"/>
          <p:nvPr/>
        </p:nvSpPr>
        <p:spPr>
          <a:xfrm>
            <a:off x="11732607" y="1040805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B806021-5D5F-46AC-8AE8-84F9AA0E0A42}"/>
              </a:ext>
            </a:extLst>
          </p:cNvPr>
          <p:cNvSpPr txBox="1"/>
          <p:nvPr/>
        </p:nvSpPr>
        <p:spPr>
          <a:xfrm>
            <a:off x="12965203" y="104080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FC1B901-E013-458F-8DC7-A917405D74DA}"/>
              </a:ext>
            </a:extLst>
          </p:cNvPr>
          <p:cNvSpPr txBox="1"/>
          <p:nvPr/>
        </p:nvSpPr>
        <p:spPr>
          <a:xfrm>
            <a:off x="14154893" y="104080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ctr"/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835017B-BFAD-427F-89A3-69931C516CFE}"/>
              </a:ext>
            </a:extLst>
          </p:cNvPr>
          <p:cNvSpPr txBox="1"/>
          <p:nvPr/>
        </p:nvSpPr>
        <p:spPr>
          <a:xfrm>
            <a:off x="10512153" y="1158954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7BEEB7A-0F27-422F-8F1B-BE0ADAF4828F}"/>
              </a:ext>
            </a:extLst>
          </p:cNvPr>
          <p:cNvSpPr txBox="1"/>
          <p:nvPr/>
        </p:nvSpPr>
        <p:spPr>
          <a:xfrm>
            <a:off x="11760570" y="1160744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D7410B7-E3C4-4472-9A1D-B46B64C780B9}"/>
              </a:ext>
            </a:extLst>
          </p:cNvPr>
          <p:cNvSpPr txBox="1"/>
          <p:nvPr/>
        </p:nvSpPr>
        <p:spPr>
          <a:xfrm>
            <a:off x="12967758" y="11607440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6D5C1B9-2279-4CC5-9465-F4BE8165FE89}"/>
              </a:ext>
            </a:extLst>
          </p:cNvPr>
          <p:cNvSpPr txBox="1"/>
          <p:nvPr/>
        </p:nvSpPr>
        <p:spPr>
          <a:xfrm>
            <a:off x="14142862" y="11596807"/>
            <a:ext cx="117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F4B6963-568A-40DA-BBC5-675D89DF5C7D}"/>
              </a:ext>
            </a:extLst>
          </p:cNvPr>
          <p:cNvSpPr txBox="1"/>
          <p:nvPr/>
        </p:nvSpPr>
        <p:spPr>
          <a:xfrm>
            <a:off x="10497170" y="1283477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ECDC9D8-B793-4023-A314-B93C38FB6BEB}"/>
              </a:ext>
            </a:extLst>
          </p:cNvPr>
          <p:cNvSpPr txBox="1"/>
          <p:nvPr/>
        </p:nvSpPr>
        <p:spPr>
          <a:xfrm>
            <a:off x="11763618" y="1283477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7BAE195-98AF-4D99-A8AF-EC5BDD230F28}"/>
              </a:ext>
            </a:extLst>
          </p:cNvPr>
          <p:cNvSpPr txBox="1"/>
          <p:nvPr/>
        </p:nvSpPr>
        <p:spPr>
          <a:xfrm>
            <a:off x="12952775" y="1283477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AE82556-EC0C-422A-BD02-4AE1314F6360}"/>
              </a:ext>
            </a:extLst>
          </p:cNvPr>
          <p:cNvSpPr txBox="1"/>
          <p:nvPr/>
        </p:nvSpPr>
        <p:spPr>
          <a:xfrm>
            <a:off x="2973065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5C660C-E1D1-4FCF-AFB0-EBE4202972E1}"/>
              </a:ext>
            </a:extLst>
          </p:cNvPr>
          <p:cNvSpPr txBox="1"/>
          <p:nvPr/>
        </p:nvSpPr>
        <p:spPr>
          <a:xfrm>
            <a:off x="4239513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044C068-AB32-40D6-856E-5A9E135E0D80}"/>
              </a:ext>
            </a:extLst>
          </p:cNvPr>
          <p:cNvSpPr txBox="1"/>
          <p:nvPr/>
        </p:nvSpPr>
        <p:spPr>
          <a:xfrm>
            <a:off x="5428670" y="91652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7E99F02-9191-4D63-A362-B30BDAB74B96}"/>
              </a:ext>
            </a:extLst>
          </p:cNvPr>
          <p:cNvSpPr txBox="1"/>
          <p:nvPr/>
        </p:nvSpPr>
        <p:spPr>
          <a:xfrm>
            <a:off x="6603774" y="915462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99A73EC-837F-4224-A3C0-B5E70CE25196}"/>
              </a:ext>
            </a:extLst>
          </p:cNvPr>
          <p:cNvSpPr txBox="1"/>
          <p:nvPr/>
        </p:nvSpPr>
        <p:spPr>
          <a:xfrm>
            <a:off x="2951799" y="1040805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F64AAFB-6FCB-456F-A673-5546E34BBDCB}"/>
              </a:ext>
            </a:extLst>
          </p:cNvPr>
          <p:cNvSpPr txBox="1"/>
          <p:nvPr/>
        </p:nvSpPr>
        <p:spPr>
          <a:xfrm>
            <a:off x="4181487" y="1040805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2E68FE9-8B59-4FBE-9E98-293E53A02ED2}"/>
              </a:ext>
            </a:extLst>
          </p:cNvPr>
          <p:cNvSpPr txBox="1"/>
          <p:nvPr/>
        </p:nvSpPr>
        <p:spPr>
          <a:xfrm>
            <a:off x="5414083" y="104080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C02AD28-DA8E-4CD0-9424-D6F8FD9540A3}"/>
              </a:ext>
            </a:extLst>
          </p:cNvPr>
          <p:cNvSpPr txBox="1"/>
          <p:nvPr/>
        </p:nvSpPr>
        <p:spPr>
          <a:xfrm>
            <a:off x="6603773" y="104080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03705E1-3FFE-4492-8DF7-B410A820D374}"/>
              </a:ext>
            </a:extLst>
          </p:cNvPr>
          <p:cNvSpPr txBox="1"/>
          <p:nvPr/>
        </p:nvSpPr>
        <p:spPr>
          <a:xfrm>
            <a:off x="2973065" y="11589546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C942220-A73E-4F1C-8090-272FF1644257}"/>
              </a:ext>
            </a:extLst>
          </p:cNvPr>
          <p:cNvSpPr txBox="1"/>
          <p:nvPr/>
        </p:nvSpPr>
        <p:spPr>
          <a:xfrm>
            <a:off x="4221482" y="1160744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F614A71-FD12-412A-95CC-32F1D642F25D}"/>
              </a:ext>
            </a:extLst>
          </p:cNvPr>
          <p:cNvSpPr txBox="1"/>
          <p:nvPr/>
        </p:nvSpPr>
        <p:spPr>
          <a:xfrm>
            <a:off x="5428670" y="1160744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BD2695D-79F1-4F2F-8D19-93F20EFB433E}"/>
              </a:ext>
            </a:extLst>
          </p:cNvPr>
          <p:cNvSpPr txBox="1"/>
          <p:nvPr/>
        </p:nvSpPr>
        <p:spPr>
          <a:xfrm>
            <a:off x="6603774" y="1159680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A58A4BF-2DF3-4624-BD45-6B63CE6E45F2}"/>
              </a:ext>
            </a:extLst>
          </p:cNvPr>
          <p:cNvSpPr txBox="1"/>
          <p:nvPr/>
        </p:nvSpPr>
        <p:spPr>
          <a:xfrm>
            <a:off x="10728100" y="2108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BC3AE65-EDB8-487D-92B8-55EDD4D2038E}"/>
              </a:ext>
            </a:extLst>
          </p:cNvPr>
          <p:cNvSpPr txBox="1"/>
          <p:nvPr/>
        </p:nvSpPr>
        <p:spPr>
          <a:xfrm>
            <a:off x="11994548" y="2108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6BEC7A0-B847-45A0-A672-F7142F44FA0A}"/>
              </a:ext>
            </a:extLst>
          </p:cNvPr>
          <p:cNvSpPr txBox="1"/>
          <p:nvPr/>
        </p:nvSpPr>
        <p:spPr>
          <a:xfrm>
            <a:off x="13183705" y="2108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1C8CB36-EEB1-4546-8BD1-B406E194E578}"/>
              </a:ext>
            </a:extLst>
          </p:cNvPr>
          <p:cNvSpPr txBox="1"/>
          <p:nvPr/>
        </p:nvSpPr>
        <p:spPr>
          <a:xfrm>
            <a:off x="14358809" y="20023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AC986C9-4E88-477A-8118-B15B7EDCED14}"/>
              </a:ext>
            </a:extLst>
          </p:cNvPr>
          <p:cNvSpPr txBox="1"/>
          <p:nvPr/>
        </p:nvSpPr>
        <p:spPr>
          <a:xfrm>
            <a:off x="10706834" y="141273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E36E359-B918-49FE-92E9-5CDDA089C900}"/>
              </a:ext>
            </a:extLst>
          </p:cNvPr>
          <p:cNvSpPr txBox="1"/>
          <p:nvPr/>
        </p:nvSpPr>
        <p:spPr>
          <a:xfrm>
            <a:off x="11936522" y="141273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73CDB9A-1DA6-4E7C-92C4-E83DD2E3FC60}"/>
              </a:ext>
            </a:extLst>
          </p:cNvPr>
          <p:cNvSpPr txBox="1"/>
          <p:nvPr/>
        </p:nvSpPr>
        <p:spPr>
          <a:xfrm>
            <a:off x="13169118" y="14127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900E09C-80AF-436A-A3D1-4BD05C3EFBA6}"/>
              </a:ext>
            </a:extLst>
          </p:cNvPr>
          <p:cNvSpPr txBox="1"/>
          <p:nvPr/>
        </p:nvSpPr>
        <p:spPr>
          <a:xfrm>
            <a:off x="14358808" y="141273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872C70D-5E69-4A97-BC8F-0F3096DA0AC9}"/>
              </a:ext>
            </a:extLst>
          </p:cNvPr>
          <p:cNvSpPr txBox="1"/>
          <p:nvPr/>
        </p:nvSpPr>
        <p:spPr>
          <a:xfrm>
            <a:off x="10728100" y="263516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1B21612-B9E8-46A5-AF52-ADBBE3103CFE}"/>
              </a:ext>
            </a:extLst>
          </p:cNvPr>
          <p:cNvSpPr txBox="1"/>
          <p:nvPr/>
        </p:nvSpPr>
        <p:spPr>
          <a:xfrm>
            <a:off x="11976517" y="26530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82BABFB-A2A5-4367-8EBB-23B874B445BA}"/>
              </a:ext>
            </a:extLst>
          </p:cNvPr>
          <p:cNvSpPr txBox="1"/>
          <p:nvPr/>
        </p:nvSpPr>
        <p:spPr>
          <a:xfrm>
            <a:off x="13183705" y="265305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84803F6-6706-4136-A3D8-105B067E5870}"/>
              </a:ext>
            </a:extLst>
          </p:cNvPr>
          <p:cNvSpPr txBox="1"/>
          <p:nvPr/>
        </p:nvSpPr>
        <p:spPr>
          <a:xfrm>
            <a:off x="14358809" y="264242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95BDE7F-F894-4C5A-89E0-41781AE34ACA}"/>
              </a:ext>
            </a:extLst>
          </p:cNvPr>
          <p:cNvSpPr txBox="1"/>
          <p:nvPr/>
        </p:nvSpPr>
        <p:spPr>
          <a:xfrm>
            <a:off x="2851325" y="17590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5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680CA72-CE41-4CAE-BAD9-E84028A30FE6}"/>
              </a:ext>
            </a:extLst>
          </p:cNvPr>
          <p:cNvSpPr txBox="1"/>
          <p:nvPr/>
        </p:nvSpPr>
        <p:spPr>
          <a:xfrm>
            <a:off x="4117773" y="17590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124A7C1-3F37-4B20-8948-602B881B5E7D}"/>
              </a:ext>
            </a:extLst>
          </p:cNvPr>
          <p:cNvSpPr txBox="1"/>
          <p:nvPr/>
        </p:nvSpPr>
        <p:spPr>
          <a:xfrm>
            <a:off x="5306930" y="17590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8C11B1D-25AF-4710-A686-65E03DAC5878}"/>
              </a:ext>
            </a:extLst>
          </p:cNvPr>
          <p:cNvSpPr txBox="1"/>
          <p:nvPr/>
        </p:nvSpPr>
        <p:spPr>
          <a:xfrm>
            <a:off x="6482034" y="16527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D65DE67-4D0D-4223-8FD2-3755B86647C1}"/>
              </a:ext>
            </a:extLst>
          </p:cNvPr>
          <p:cNvSpPr txBox="1"/>
          <p:nvPr/>
        </p:nvSpPr>
        <p:spPr>
          <a:xfrm>
            <a:off x="2830059" y="141871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B0B784D-C4C1-4B4C-A2AF-CE7CCA718543}"/>
              </a:ext>
            </a:extLst>
          </p:cNvPr>
          <p:cNvSpPr txBox="1"/>
          <p:nvPr/>
        </p:nvSpPr>
        <p:spPr>
          <a:xfrm>
            <a:off x="4059747" y="141871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90.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25A1C4B-4AE6-46D7-B416-4AE217B67AA4}"/>
              </a:ext>
            </a:extLst>
          </p:cNvPr>
          <p:cNvSpPr txBox="1"/>
          <p:nvPr/>
        </p:nvSpPr>
        <p:spPr>
          <a:xfrm>
            <a:off x="5292343" y="14187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63D4516-3F1C-4CF3-876C-03A26E7DCE2F}"/>
              </a:ext>
            </a:extLst>
          </p:cNvPr>
          <p:cNvSpPr txBox="1"/>
          <p:nvPr/>
        </p:nvSpPr>
        <p:spPr>
          <a:xfrm>
            <a:off x="6482033" y="141871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14A36E4-FA7B-4C6A-BAD4-26EAB568CC30}"/>
              </a:ext>
            </a:extLst>
          </p:cNvPr>
          <p:cNvSpPr txBox="1"/>
          <p:nvPr/>
        </p:nvSpPr>
        <p:spPr>
          <a:xfrm>
            <a:off x="2851325" y="260020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528F4E1-3404-424D-ACAD-C44F22C3BE18}"/>
              </a:ext>
            </a:extLst>
          </p:cNvPr>
          <p:cNvSpPr txBox="1"/>
          <p:nvPr/>
        </p:nvSpPr>
        <p:spPr>
          <a:xfrm>
            <a:off x="4099742" y="261809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9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46F0BC5-11D5-492C-B07F-4CC8E5BDC6AA}"/>
              </a:ext>
            </a:extLst>
          </p:cNvPr>
          <p:cNvSpPr txBox="1"/>
          <p:nvPr/>
        </p:nvSpPr>
        <p:spPr>
          <a:xfrm>
            <a:off x="5306930" y="261809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C097AFB-7122-4B7E-950F-0087F0D68909}"/>
              </a:ext>
            </a:extLst>
          </p:cNvPr>
          <p:cNvSpPr txBox="1"/>
          <p:nvPr/>
        </p:nvSpPr>
        <p:spPr>
          <a:xfrm>
            <a:off x="6482034" y="260746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5F0F271-47E9-4E0E-889E-B9DE18C347F6}"/>
              </a:ext>
            </a:extLst>
          </p:cNvPr>
          <p:cNvSpPr txBox="1"/>
          <p:nvPr/>
        </p:nvSpPr>
        <p:spPr>
          <a:xfrm>
            <a:off x="2874898" y="387166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91D7293-567E-4B95-BC9B-9D15A1BEFF85}"/>
              </a:ext>
            </a:extLst>
          </p:cNvPr>
          <p:cNvSpPr txBox="1"/>
          <p:nvPr/>
        </p:nvSpPr>
        <p:spPr>
          <a:xfrm>
            <a:off x="4141346" y="387166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oxP3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4F383FE-ABCB-4B08-8C44-93BAECE6D6C2}"/>
              </a:ext>
            </a:extLst>
          </p:cNvPr>
          <p:cNvSpPr txBox="1"/>
          <p:nvPr/>
        </p:nvSpPr>
        <p:spPr>
          <a:xfrm>
            <a:off x="5330503" y="387166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E50FA9D-4A6D-4988-978C-28D6A6A56C1D}"/>
              </a:ext>
            </a:extLst>
          </p:cNvPr>
          <p:cNvSpPr txBox="1"/>
          <p:nvPr/>
        </p:nvSpPr>
        <p:spPr>
          <a:xfrm>
            <a:off x="6505607" y="386103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9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AFB9D6C-E9BB-4669-84C2-A785E47230A1}"/>
              </a:ext>
            </a:extLst>
          </p:cNvPr>
          <p:cNvSpPr txBox="1"/>
          <p:nvPr/>
        </p:nvSpPr>
        <p:spPr>
          <a:xfrm>
            <a:off x="2853632" y="511447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072A460-CBD9-4DA8-A71B-3580B683FAC2}"/>
              </a:ext>
            </a:extLst>
          </p:cNvPr>
          <p:cNvSpPr txBox="1"/>
          <p:nvPr/>
        </p:nvSpPr>
        <p:spPr>
          <a:xfrm>
            <a:off x="4083320" y="511447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383D0B55-E90D-463C-A0A5-698B0EC453F1}"/>
              </a:ext>
            </a:extLst>
          </p:cNvPr>
          <p:cNvSpPr txBox="1"/>
          <p:nvPr/>
        </p:nvSpPr>
        <p:spPr>
          <a:xfrm>
            <a:off x="5315916" y="5114470"/>
            <a:ext cx="11661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335(NKp46)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73900FE-47B3-4CF3-A3B2-B9E0F59E79A9}"/>
              </a:ext>
            </a:extLst>
          </p:cNvPr>
          <p:cNvSpPr txBox="1"/>
          <p:nvPr/>
        </p:nvSpPr>
        <p:spPr>
          <a:xfrm>
            <a:off x="6505606" y="511447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KLRG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5D4A42A-3348-4438-9B81-9A2ED3012904}"/>
              </a:ext>
            </a:extLst>
          </p:cNvPr>
          <p:cNvSpPr txBox="1"/>
          <p:nvPr/>
        </p:nvSpPr>
        <p:spPr>
          <a:xfrm>
            <a:off x="2874898" y="62959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CR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9C3ED83-4F2D-4185-B2F4-456D5EF16001}"/>
              </a:ext>
            </a:extLst>
          </p:cNvPr>
          <p:cNvSpPr txBox="1"/>
          <p:nvPr/>
        </p:nvSpPr>
        <p:spPr>
          <a:xfrm>
            <a:off x="4123315" y="63138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8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5625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C0C071D-F436-4E85-A7A9-475367FF81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2362" y="5467302"/>
            <a:ext cx="2238375" cy="21907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77AC5F9-504F-4B30-8265-66ABD6655267}"/>
              </a:ext>
            </a:extLst>
          </p:cNvPr>
          <p:cNvSpPr txBox="1"/>
          <p:nvPr/>
        </p:nvSpPr>
        <p:spPr>
          <a:xfrm>
            <a:off x="7040140" y="5840547"/>
            <a:ext cx="866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alibri" panose="020F0502020204030204" pitchFamily="34" charset="0"/>
                <a:ea typeface="Arial" panose="020B0604020202020204" pitchFamily="34" charset="0"/>
              </a:rPr>
              <a:t>Microglia</a:t>
            </a:r>
            <a:endParaRPr lang="en-US" sz="10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D24779-71C5-4E88-B0C2-D45738A8D0E1}"/>
              </a:ext>
            </a:extLst>
          </p:cNvPr>
          <p:cNvSpPr txBox="1"/>
          <p:nvPr/>
        </p:nvSpPr>
        <p:spPr>
          <a:xfrm>
            <a:off x="7439385" y="6697055"/>
            <a:ext cx="866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alibri" panose="020F0502020204030204" pitchFamily="34" charset="0"/>
                <a:ea typeface="Arial" panose="020B0604020202020204" pitchFamily="34" charset="0"/>
              </a:rPr>
              <a:t>CD45+ Cells</a:t>
            </a:r>
            <a:endParaRPr lang="en-US" sz="10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7711E9-0FE8-46D2-A1E3-9CC00F8F9964}"/>
              </a:ext>
            </a:extLst>
          </p:cNvPr>
          <p:cNvSpPr txBox="1"/>
          <p:nvPr/>
        </p:nvSpPr>
        <p:spPr>
          <a:xfrm>
            <a:off x="5411974" y="7797365"/>
            <a:ext cx="4572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7. Gating of microglia and CD45+ immune cells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Microglia are CD45 low and CD11b+ while immune cells have higher expression of CD45. 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8665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04EC37B-D408-4D71-A3E6-24BF820C77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1450" y="4219575"/>
            <a:ext cx="7886700" cy="52959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AF69DBE-8C67-44D5-B4E1-3039DB0E42C1}"/>
              </a:ext>
            </a:extLst>
          </p:cNvPr>
          <p:cNvSpPr txBox="1"/>
          <p:nvPr/>
        </p:nvSpPr>
        <p:spPr>
          <a:xfrm>
            <a:off x="3981450" y="9515477"/>
            <a:ext cx="7886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Figure 8. Heatmaps of example </a:t>
            </a:r>
            <a:r>
              <a:rPr lang="en-US" sz="1200" b="1" dirty="0" err="1">
                <a:latin typeface="Calibri" panose="020F0502020204030204" pitchFamily="34" charset="0"/>
                <a:ea typeface="Arial" panose="020B0604020202020204" pitchFamily="34" charset="0"/>
              </a:rPr>
              <a:t>tSNE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of myeloid populations in the liver with customizations to the described panel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Myeloid populations with substitutions (replace APC - KLRG1 for APC - TIM4) and additions (PerCPCy5.5 – Clec2) to the panel. (n=3) Multigraph heat map overlays are shown.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8AAF5E3-6837-44C3-BE01-A7DE09C8EE1B}"/>
              </a:ext>
            </a:extLst>
          </p:cNvPr>
          <p:cNvSpPr txBox="1"/>
          <p:nvPr/>
        </p:nvSpPr>
        <p:spPr>
          <a:xfrm>
            <a:off x="6779940" y="438761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F4/80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3D5C440-727C-4CA6-B0FB-076D819C74E4}"/>
              </a:ext>
            </a:extLst>
          </p:cNvPr>
          <p:cNvSpPr txBox="1"/>
          <p:nvPr/>
        </p:nvSpPr>
        <p:spPr>
          <a:xfrm>
            <a:off x="8028357" y="4388753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PD1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F4BF74-6413-4A8B-9858-159EDB7CDBB5}"/>
              </a:ext>
            </a:extLst>
          </p:cNvPr>
          <p:cNvSpPr txBox="1"/>
          <p:nvPr/>
        </p:nvSpPr>
        <p:spPr>
          <a:xfrm>
            <a:off x="9235545" y="4388752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MHCII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72EB74-CFAC-42D8-90E9-55A77662EEF0}"/>
              </a:ext>
            </a:extLst>
          </p:cNvPr>
          <p:cNvSpPr txBox="1"/>
          <p:nvPr/>
        </p:nvSpPr>
        <p:spPr>
          <a:xfrm>
            <a:off x="10442732" y="4387614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27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2E5B75-71BA-4C5C-BCEF-FC88EFA45BE4}"/>
              </a:ext>
            </a:extLst>
          </p:cNvPr>
          <p:cNvSpPr txBox="1"/>
          <p:nvPr/>
        </p:nvSpPr>
        <p:spPr>
          <a:xfrm>
            <a:off x="6758674" y="56315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4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68A64E-98C6-4DBC-AA68-3EEF90EA34B3}"/>
              </a:ext>
            </a:extLst>
          </p:cNvPr>
          <p:cNvSpPr txBox="1"/>
          <p:nvPr/>
        </p:nvSpPr>
        <p:spPr>
          <a:xfrm>
            <a:off x="7988362" y="56315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G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E5155CA-64CF-43C6-8FF8-7FFA9D738FD9}"/>
              </a:ext>
            </a:extLst>
          </p:cNvPr>
          <p:cNvSpPr txBox="1"/>
          <p:nvPr/>
        </p:nvSpPr>
        <p:spPr>
          <a:xfrm>
            <a:off x="9218050" y="5631558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5483E7-AC8B-4AA4-9B34-8083D7577FC6}"/>
              </a:ext>
            </a:extLst>
          </p:cNvPr>
          <p:cNvSpPr txBox="1"/>
          <p:nvPr/>
        </p:nvSpPr>
        <p:spPr>
          <a:xfrm>
            <a:off x="10442732" y="5631557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206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B216DF-18AD-4267-B79B-4ACF269E0EBE}"/>
              </a:ext>
            </a:extLst>
          </p:cNvPr>
          <p:cNvSpPr txBox="1"/>
          <p:nvPr/>
        </p:nvSpPr>
        <p:spPr>
          <a:xfrm>
            <a:off x="6758674" y="685265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Ly6C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9EF005-3348-4AFC-A2CC-F656C6EAD4AF}"/>
              </a:ext>
            </a:extLst>
          </p:cNvPr>
          <p:cNvSpPr txBox="1"/>
          <p:nvPr/>
        </p:nvSpPr>
        <p:spPr>
          <a:xfrm>
            <a:off x="8028357" y="6830940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62L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A6A264-9C33-42A0-AFA9-2DE2090B031B}"/>
              </a:ext>
            </a:extLst>
          </p:cNvPr>
          <p:cNvSpPr txBox="1"/>
          <p:nvPr/>
        </p:nvSpPr>
        <p:spPr>
          <a:xfrm>
            <a:off x="9235545" y="6830939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D11b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BA7040-BF68-4676-ADF5-413FA0B8EA0D}"/>
              </a:ext>
            </a:extLst>
          </p:cNvPr>
          <p:cNvSpPr txBox="1"/>
          <p:nvPr/>
        </p:nvSpPr>
        <p:spPr>
          <a:xfrm>
            <a:off x="10442731" y="6852651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TIM4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C1578E9-EC53-4252-B333-B4946F285A18}"/>
              </a:ext>
            </a:extLst>
          </p:cNvPr>
          <p:cNvSpPr txBox="1"/>
          <p:nvPr/>
        </p:nvSpPr>
        <p:spPr>
          <a:xfrm>
            <a:off x="6758674" y="8073745"/>
            <a:ext cx="67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Clec2</a:t>
            </a:r>
            <a:endParaRPr lang="en-US" sz="1200" b="1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92769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B78C93F-C320-46CB-A281-F4B2B0BF47C0}"/>
              </a:ext>
            </a:extLst>
          </p:cNvPr>
          <p:cNvSpPr txBox="1"/>
          <p:nvPr/>
        </p:nvSpPr>
        <p:spPr>
          <a:xfrm>
            <a:off x="4629996" y="10094262"/>
            <a:ext cx="629518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Supplemental Table 1. Working Concentrations.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Stock and working concentrations for antibodies and viability dye used in the described panel.</a:t>
            </a:r>
            <a:r>
              <a:rPr lang="en-US" sz="1200" b="1" dirty="0">
                <a:latin typeface="Calibri" panose="020F0502020204030204" pitchFamily="34" charset="0"/>
                <a:ea typeface="Arial" panose="020B0604020202020204" pitchFamily="34" charset="0"/>
              </a:rPr>
              <a:t> 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FC Block (2.4G2) used is made in house, </a:t>
            </a:r>
            <a:r>
              <a:rPr lang="en-US" sz="1200" dirty="0" err="1">
                <a:latin typeface="Calibri" panose="020F0502020204030204" pitchFamily="34" charset="0"/>
                <a:ea typeface="Arial" panose="020B0604020202020204" pitchFamily="34" charset="0"/>
              </a:rPr>
              <a:t>Biolegend</a:t>
            </a:r>
            <a:r>
              <a:rPr lang="en-US" sz="1200" dirty="0">
                <a:latin typeface="Calibri" panose="020F0502020204030204" pitchFamily="34" charset="0"/>
                <a:ea typeface="Arial" panose="020B0604020202020204" pitchFamily="34" charset="0"/>
              </a:rPr>
              <a:t> equivalent also included in table for reference. Some vendors do not have recommended working concentrations*.  </a:t>
            </a:r>
            <a:endParaRPr lang="en-US" sz="1200" dirty="0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7D60C1C4-94FC-4F70-A316-70FDA4A291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1437082"/>
              </p:ext>
            </p:extLst>
          </p:nvPr>
        </p:nvGraphicFramePr>
        <p:xfrm>
          <a:off x="4629996" y="3992254"/>
          <a:ext cx="6295181" cy="61020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99512">
                  <a:extLst>
                    <a:ext uri="{9D8B030D-6E8A-4147-A177-3AD203B41FA5}">
                      <a16:colId xmlns:a16="http://schemas.microsoft.com/office/drawing/2014/main" val="3481451090"/>
                    </a:ext>
                  </a:extLst>
                </a:gridCol>
                <a:gridCol w="1010653">
                  <a:extLst>
                    <a:ext uri="{9D8B030D-6E8A-4147-A177-3AD203B41FA5}">
                      <a16:colId xmlns:a16="http://schemas.microsoft.com/office/drawing/2014/main" val="2809422188"/>
                    </a:ext>
                  </a:extLst>
                </a:gridCol>
                <a:gridCol w="806116">
                  <a:extLst>
                    <a:ext uri="{9D8B030D-6E8A-4147-A177-3AD203B41FA5}">
                      <a16:colId xmlns:a16="http://schemas.microsoft.com/office/drawing/2014/main" val="2566633261"/>
                    </a:ext>
                  </a:extLst>
                </a:gridCol>
                <a:gridCol w="1778700">
                  <a:extLst>
                    <a:ext uri="{9D8B030D-6E8A-4147-A177-3AD203B41FA5}">
                      <a16:colId xmlns:a16="http://schemas.microsoft.com/office/drawing/2014/main" val="1041066150"/>
                    </a:ext>
                  </a:extLst>
                </a:gridCol>
                <a:gridCol w="1600200">
                  <a:extLst>
                    <a:ext uri="{9D8B030D-6E8A-4147-A177-3AD203B41FA5}">
                      <a16:colId xmlns:a16="http://schemas.microsoft.com/office/drawing/2014/main" val="572225790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Marker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Fluorescent Tag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Stock Concentration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+mn-lt"/>
                        </a:rPr>
                        <a:t>Vendor Working Concentration Recommendation*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+mn-lt"/>
                        </a:rPr>
                        <a:t>VCU Working Concentration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0859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5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V395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1µg/µ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101990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4-8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V496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707555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V737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805170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279 (PD-1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421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33823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HC Class II (I-A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luor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45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1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901258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90.2 (THY1.2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48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367977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27 (IL-7Ra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51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13406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570</a:t>
                      </a:r>
                      <a:endParaRPr lang="en-US" sz="100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Lot Specific – 0.1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+mn-lt"/>
                        </a:rPr>
                        <a:t>5µL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0.5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3479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y-6G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605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002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65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Lot Specific – 0.1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5µL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05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704543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711</a:t>
                      </a:r>
                      <a:endParaRPr lang="en-US" sz="100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 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06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5760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err="1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Rγδ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V786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20812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206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CP-eFluor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71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1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78844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XP3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488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Lot Specific – 0.5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+mn-lt"/>
                        </a:rPr>
                        <a:t>5µL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5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982730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y-6C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82685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9b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-Dazzle 594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17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7703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62L (L-Selectin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-Cy5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388338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1b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-Fire 64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5648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35 (NKp46)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-Cy7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1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811922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LRG1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589005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Rβ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70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5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1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25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204956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-Fire 750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+mn-lt"/>
                        </a:rPr>
                        <a:t>0.2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0.25µg/test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1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g/</a:t>
                      </a:r>
                      <a:r>
                        <a:rPr lang="en-US" sz="1000" dirty="0">
                          <a:latin typeface="+mn-lt"/>
                        </a:rPr>
                        <a:t>µ</a:t>
                      </a: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27787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+mn-lt"/>
                          <a:ea typeface="Arial" panose="020B0604020202020204" pitchFamily="34" charset="0"/>
                          <a:cs typeface="Times New Roman" panose="02020603050405020304" pitchFamily="18" charset="0"/>
                        </a:rPr>
                        <a:t>Zombie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IR</a:t>
                      </a:r>
                      <a:endParaRPr lang="en-US" sz="1000" dirty="0">
                        <a:effectLst/>
                        <a:latin typeface="+mn-lt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5414" marR="1541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1:100 dilution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1:200 dilution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501797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+mn-lt"/>
                        </a:rPr>
                        <a:t>FC Block (2.4G2)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5849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+mn-lt"/>
                        </a:rPr>
                        <a:t>2.28mg/m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1µL</a:t>
                      </a:r>
                    </a:p>
                  </a:txBody>
                  <a:tcPr marL="20553" marR="20553" marT="10276" marB="1027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81352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63630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50</TotalTime>
  <Words>1080</Words>
  <Application>Microsoft Office PowerPoint</Application>
  <PresentationFormat>Custom</PresentationFormat>
  <Paragraphs>33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ison Isbell</dc:creator>
  <cp:lastModifiedBy>Rebecca Martin</cp:lastModifiedBy>
  <cp:revision>154</cp:revision>
  <dcterms:created xsi:type="dcterms:W3CDTF">2025-04-23T15:35:13Z</dcterms:created>
  <dcterms:modified xsi:type="dcterms:W3CDTF">2025-10-29T16:52:59Z</dcterms:modified>
</cp:coreProperties>
</file>